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7"/>
  </p:notesMasterIdLst>
  <p:handoutMasterIdLst>
    <p:handoutMasterId r:id="rId18"/>
  </p:handoutMasterIdLst>
  <p:sldIdLst>
    <p:sldId id="260" r:id="rId6"/>
    <p:sldId id="262" r:id="rId7"/>
    <p:sldId id="273" r:id="rId8"/>
    <p:sldId id="263" r:id="rId9"/>
    <p:sldId id="264" r:id="rId10"/>
    <p:sldId id="271" r:id="rId11"/>
    <p:sldId id="272" r:id="rId12"/>
    <p:sldId id="265" r:id="rId13"/>
    <p:sldId id="266" r:id="rId14"/>
    <p:sldId id="269" r:id="rId15"/>
    <p:sldId id="270" r:id="rId16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674E44C-D0D6-1B45-B891-4FA54C88CA99}" v="14" dt="2022-06-20T03:43:50.49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94694"/>
  </p:normalViewPr>
  <p:slideViewPr>
    <p:cSldViewPr snapToGrid="0" showGuides="1">
      <p:cViewPr varScale="1">
        <p:scale>
          <a:sx n="156" d="100"/>
          <a:sy n="156" d="100"/>
        </p:scale>
        <p:origin x="576" y="16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handoutMaster" Target="handoutMasters/handoutMaster1.xml"/><Relationship Id="rId3" Type="http://schemas.openxmlformats.org/officeDocument/2006/relationships/slideMaster" Target="slideMasters/slideMaster3.xml"/><Relationship Id="rId21" Type="http://schemas.openxmlformats.org/officeDocument/2006/relationships/theme" Target="theme/theme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24" Type="http://schemas.microsoft.com/office/2015/10/relationships/revisionInfo" Target="revisionInfo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microsoft.com/office/2016/11/relationships/changesInfo" Target="changesInfos/changesInfo1.xml"/><Relationship Id="rId10" Type="http://schemas.openxmlformats.org/officeDocument/2006/relationships/slide" Target="slides/slide5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enichiro otsuka" userId="99cd8c0872cf49df" providerId="LiveId" clId="{AE41CF4B-C10A-405B-A3FD-152C204BB558}"/>
    <pc:docChg chg="custSel modSld">
      <pc:chgData name="kenichiro otsuka" userId="99cd8c0872cf49df" providerId="LiveId" clId="{AE41CF4B-C10A-405B-A3FD-152C204BB558}" dt="2022-05-04T03:19:54.456" v="11" actId="1076"/>
      <pc:docMkLst>
        <pc:docMk/>
      </pc:docMkLst>
      <pc:sldChg chg="modSp mod">
        <pc:chgData name="kenichiro otsuka" userId="99cd8c0872cf49df" providerId="LiveId" clId="{AE41CF4B-C10A-405B-A3FD-152C204BB558}" dt="2022-05-04T03:19:54.456" v="11" actId="1076"/>
        <pc:sldMkLst>
          <pc:docMk/>
          <pc:sldMk cId="2298962906" sldId="270"/>
        </pc:sldMkLst>
        <pc:spChg chg="mod">
          <ac:chgData name="kenichiro otsuka" userId="99cd8c0872cf49df" providerId="LiveId" clId="{AE41CF4B-C10A-405B-A3FD-152C204BB558}" dt="2022-05-04T03:19:54.456" v="11" actId="1076"/>
          <ac:spMkLst>
            <pc:docMk/>
            <pc:sldMk cId="2298962906" sldId="270"/>
            <ac:spMk id="6" creationId="{13C14CE8-CAF4-0BCA-8D51-2B63CC9314CB}"/>
          </ac:spMkLst>
        </pc:spChg>
      </pc:sldChg>
    </pc:docChg>
  </pc:docChgLst>
  <pc:docChgLst>
    <pc:chgData name="kenichiro otsuka" userId="99cd8c0872cf49df" providerId="LiveId" clId="{EA56EBD6-6E93-4CD6-9BC3-F976E780926E}"/>
    <pc:docChg chg="custSel modSld">
      <pc:chgData name="kenichiro otsuka" userId="99cd8c0872cf49df" providerId="LiveId" clId="{EA56EBD6-6E93-4CD6-9BC3-F976E780926E}" dt="2022-04-30T13:44:41.559" v="199" actId="1076"/>
      <pc:docMkLst>
        <pc:docMk/>
      </pc:docMkLst>
      <pc:sldChg chg="modSp mod">
        <pc:chgData name="kenichiro otsuka" userId="99cd8c0872cf49df" providerId="LiveId" clId="{EA56EBD6-6E93-4CD6-9BC3-F976E780926E}" dt="2022-04-30T13:38:17.091" v="18" actId="207"/>
        <pc:sldMkLst>
          <pc:docMk/>
          <pc:sldMk cId="1089892516" sldId="260"/>
        </pc:sldMkLst>
        <pc:spChg chg="mod">
          <ac:chgData name="kenichiro otsuka" userId="99cd8c0872cf49df" providerId="LiveId" clId="{EA56EBD6-6E93-4CD6-9BC3-F976E780926E}" dt="2022-04-30T13:38:17.091" v="18" actId="207"/>
          <ac:spMkLst>
            <pc:docMk/>
            <pc:sldMk cId="1089892516" sldId="260"/>
            <ac:spMk id="3" creationId="{00000000-0000-0000-0000-000000000000}"/>
          </ac:spMkLst>
        </pc:spChg>
        <pc:spChg chg="mod">
          <ac:chgData name="kenichiro otsuka" userId="99cd8c0872cf49df" providerId="LiveId" clId="{EA56EBD6-6E93-4CD6-9BC3-F976E780926E}" dt="2022-04-30T13:37:49.612" v="14" actId="20577"/>
          <ac:spMkLst>
            <pc:docMk/>
            <pc:sldMk cId="1089892516" sldId="260"/>
            <ac:spMk id="4" creationId="{00000000-0000-0000-0000-000000000000}"/>
          </ac:spMkLst>
        </pc:spChg>
      </pc:sldChg>
      <pc:sldChg chg="modSp mod">
        <pc:chgData name="kenichiro otsuka" userId="99cd8c0872cf49df" providerId="LiveId" clId="{EA56EBD6-6E93-4CD6-9BC3-F976E780926E}" dt="2022-04-30T13:40:35.303" v="143" actId="20577"/>
        <pc:sldMkLst>
          <pc:docMk/>
          <pc:sldMk cId="2946818097" sldId="265"/>
        </pc:sldMkLst>
        <pc:spChg chg="mod">
          <ac:chgData name="kenichiro otsuka" userId="99cd8c0872cf49df" providerId="LiveId" clId="{EA56EBD6-6E93-4CD6-9BC3-F976E780926E}" dt="2022-04-30T13:40:35.303" v="143" actId="20577"/>
          <ac:spMkLst>
            <pc:docMk/>
            <pc:sldMk cId="2946818097" sldId="265"/>
            <ac:spMk id="5" creationId="{00000000-0000-0000-0000-000000000000}"/>
          </ac:spMkLst>
        </pc:spChg>
      </pc:sldChg>
      <pc:sldChg chg="modSp mod">
        <pc:chgData name="kenichiro otsuka" userId="99cd8c0872cf49df" providerId="LiveId" clId="{EA56EBD6-6E93-4CD6-9BC3-F976E780926E}" dt="2022-04-30T13:42:44.796" v="166" actId="1076"/>
        <pc:sldMkLst>
          <pc:docMk/>
          <pc:sldMk cId="349600417" sldId="266"/>
        </pc:sldMkLst>
        <pc:spChg chg="mod">
          <ac:chgData name="kenichiro otsuka" userId="99cd8c0872cf49df" providerId="LiveId" clId="{EA56EBD6-6E93-4CD6-9BC3-F976E780926E}" dt="2022-04-30T13:42:44.796" v="166" actId="1076"/>
          <ac:spMkLst>
            <pc:docMk/>
            <pc:sldMk cId="349600417" sldId="266"/>
            <ac:spMk id="3" creationId="{00000000-0000-0000-0000-000000000000}"/>
          </ac:spMkLst>
        </pc:spChg>
        <pc:spChg chg="mod">
          <ac:chgData name="kenichiro otsuka" userId="99cd8c0872cf49df" providerId="LiveId" clId="{EA56EBD6-6E93-4CD6-9BC3-F976E780926E}" dt="2022-04-30T13:42:41.414" v="165" actId="1076"/>
          <ac:spMkLst>
            <pc:docMk/>
            <pc:sldMk cId="349600417" sldId="266"/>
            <ac:spMk id="5" creationId="{00000000-0000-0000-0000-000000000000}"/>
          </ac:spMkLst>
        </pc:spChg>
        <pc:spChg chg="mod">
          <ac:chgData name="kenichiro otsuka" userId="99cd8c0872cf49df" providerId="LiveId" clId="{EA56EBD6-6E93-4CD6-9BC3-F976E780926E}" dt="2022-04-30T13:42:31.559" v="163" actId="2711"/>
          <ac:spMkLst>
            <pc:docMk/>
            <pc:sldMk cId="349600417" sldId="266"/>
            <ac:spMk id="6" creationId="{00000000-0000-0000-0000-000000000000}"/>
          </ac:spMkLst>
        </pc:spChg>
      </pc:sldChg>
      <pc:sldChg chg="addSp delSp modSp mod">
        <pc:chgData name="kenichiro otsuka" userId="99cd8c0872cf49df" providerId="LiveId" clId="{EA56EBD6-6E93-4CD6-9BC3-F976E780926E}" dt="2022-04-30T13:41:30.185" v="157" actId="1038"/>
        <pc:sldMkLst>
          <pc:docMk/>
          <pc:sldMk cId="1470050889" sldId="269"/>
        </pc:sldMkLst>
        <pc:spChg chg="del">
          <ac:chgData name="kenichiro otsuka" userId="99cd8c0872cf49df" providerId="LiveId" clId="{EA56EBD6-6E93-4CD6-9BC3-F976E780926E}" dt="2022-04-30T13:41:16.814" v="147" actId="478"/>
          <ac:spMkLst>
            <pc:docMk/>
            <pc:sldMk cId="1470050889" sldId="269"/>
            <ac:spMk id="9" creationId="{00000000-0000-0000-0000-000000000000}"/>
          </ac:spMkLst>
        </pc:spChg>
        <pc:spChg chg="del">
          <ac:chgData name="kenichiro otsuka" userId="99cd8c0872cf49df" providerId="LiveId" clId="{EA56EBD6-6E93-4CD6-9BC3-F976E780926E}" dt="2022-04-30T13:41:18.495" v="148" actId="478"/>
          <ac:spMkLst>
            <pc:docMk/>
            <pc:sldMk cId="1470050889" sldId="269"/>
            <ac:spMk id="14" creationId="{0CF276F1-ED10-3441-B0C6-0041B81C54AE}"/>
          </ac:spMkLst>
        </pc:spChg>
        <pc:picChg chg="add mod">
          <ac:chgData name="kenichiro otsuka" userId="99cd8c0872cf49df" providerId="LiveId" clId="{EA56EBD6-6E93-4CD6-9BC3-F976E780926E}" dt="2022-04-30T13:41:30.185" v="157" actId="1038"/>
          <ac:picMkLst>
            <pc:docMk/>
            <pc:sldMk cId="1470050889" sldId="269"/>
            <ac:picMk id="10" creationId="{9AA7A7CE-8B36-EA06-C896-2395251B8DAA}"/>
          </ac:picMkLst>
        </pc:picChg>
      </pc:sldChg>
      <pc:sldChg chg="delSp modSp mod">
        <pc:chgData name="kenichiro otsuka" userId="99cd8c0872cf49df" providerId="LiveId" clId="{EA56EBD6-6E93-4CD6-9BC3-F976E780926E}" dt="2022-04-30T13:44:41.559" v="199" actId="1076"/>
        <pc:sldMkLst>
          <pc:docMk/>
          <pc:sldMk cId="2298962906" sldId="270"/>
        </pc:sldMkLst>
        <pc:spChg chg="del">
          <ac:chgData name="kenichiro otsuka" userId="99cd8c0872cf49df" providerId="LiveId" clId="{EA56EBD6-6E93-4CD6-9BC3-F976E780926E}" dt="2022-04-30T13:44:28.449" v="196" actId="478"/>
          <ac:spMkLst>
            <pc:docMk/>
            <pc:sldMk cId="2298962906" sldId="270"/>
            <ac:spMk id="3" creationId="{00000000-0000-0000-0000-000000000000}"/>
          </ac:spMkLst>
        </pc:spChg>
        <pc:spChg chg="mod">
          <ac:chgData name="kenichiro otsuka" userId="99cd8c0872cf49df" providerId="LiveId" clId="{EA56EBD6-6E93-4CD6-9BC3-F976E780926E}" dt="2022-04-30T13:44:41.559" v="199" actId="1076"/>
          <ac:spMkLst>
            <pc:docMk/>
            <pc:sldMk cId="2298962906" sldId="270"/>
            <ac:spMk id="5" creationId="{00000000-0000-0000-0000-000000000000}"/>
          </ac:spMkLst>
        </pc:spChg>
      </pc:sldChg>
      <pc:sldChg chg="addSp delSp modSp mod">
        <pc:chgData name="kenichiro otsuka" userId="99cd8c0872cf49df" providerId="LiveId" clId="{EA56EBD6-6E93-4CD6-9BC3-F976E780926E}" dt="2022-04-30T13:39:23.491" v="50" actId="1076"/>
        <pc:sldMkLst>
          <pc:docMk/>
          <pc:sldMk cId="3134786594" sldId="272"/>
        </pc:sldMkLst>
        <pc:spChg chg="mod">
          <ac:chgData name="kenichiro otsuka" userId="99cd8c0872cf49df" providerId="LiveId" clId="{EA56EBD6-6E93-4CD6-9BC3-F976E780926E}" dt="2022-04-30T13:39:09.057" v="48" actId="20577"/>
          <ac:spMkLst>
            <pc:docMk/>
            <pc:sldMk cId="3134786594" sldId="272"/>
            <ac:spMk id="5" creationId="{00000000-0000-0000-0000-000000000000}"/>
          </ac:spMkLst>
        </pc:spChg>
        <pc:picChg chg="add mod modCrop">
          <ac:chgData name="kenichiro otsuka" userId="99cd8c0872cf49df" providerId="LiveId" clId="{EA56EBD6-6E93-4CD6-9BC3-F976E780926E}" dt="2022-04-30T13:39:23.491" v="50" actId="1076"/>
          <ac:picMkLst>
            <pc:docMk/>
            <pc:sldMk cId="3134786594" sldId="272"/>
            <ac:picMk id="7" creationId="{31616EF6-1CB4-4F48-1395-0F19AB8D5924}"/>
          </ac:picMkLst>
        </pc:picChg>
        <pc:picChg chg="del">
          <ac:chgData name="kenichiro otsuka" userId="99cd8c0872cf49df" providerId="LiveId" clId="{EA56EBD6-6E93-4CD6-9BC3-F976E780926E}" dt="2022-04-30T13:36:02.983" v="0" actId="478"/>
          <ac:picMkLst>
            <pc:docMk/>
            <pc:sldMk cId="3134786594" sldId="272"/>
            <ac:picMk id="15" creationId="{09E02468-C47C-B540-B876-E46C9999B014}"/>
          </ac:picMkLst>
        </pc:picChg>
      </pc:sldChg>
    </pc:docChg>
  </pc:docChgLst>
  <pc:docChgLst>
    <pc:chgData name="kenichiro otsuka" userId="99cd8c0872cf49df" providerId="LiveId" clId="{16396DD9-8CC4-3040-80AC-A46C47344420}"/>
    <pc:docChg chg="undo custSel modSld">
      <pc:chgData name="kenichiro otsuka" userId="99cd8c0872cf49df" providerId="LiveId" clId="{16396DD9-8CC4-3040-80AC-A46C47344420}" dt="2022-05-01T07:18:51.853" v="336" actId="113"/>
      <pc:docMkLst>
        <pc:docMk/>
      </pc:docMkLst>
      <pc:sldChg chg="modSp mod">
        <pc:chgData name="kenichiro otsuka" userId="99cd8c0872cf49df" providerId="LiveId" clId="{16396DD9-8CC4-3040-80AC-A46C47344420}" dt="2022-05-01T07:18:51.853" v="336" actId="113"/>
        <pc:sldMkLst>
          <pc:docMk/>
          <pc:sldMk cId="2079782646" sldId="262"/>
        </pc:sldMkLst>
        <pc:spChg chg="mod">
          <ac:chgData name="kenichiro otsuka" userId="99cd8c0872cf49df" providerId="LiveId" clId="{16396DD9-8CC4-3040-80AC-A46C47344420}" dt="2022-05-01T07:18:51.853" v="336" actId="113"/>
          <ac:spMkLst>
            <pc:docMk/>
            <pc:sldMk cId="2079782646" sldId="262"/>
            <ac:spMk id="2" creationId="{00000000-0000-0000-0000-000000000000}"/>
          </ac:spMkLst>
        </pc:spChg>
        <pc:spChg chg="mod">
          <ac:chgData name="kenichiro otsuka" userId="99cd8c0872cf49df" providerId="LiveId" clId="{16396DD9-8CC4-3040-80AC-A46C47344420}" dt="2022-05-01T07:12:12.022" v="159" actId="20577"/>
          <ac:spMkLst>
            <pc:docMk/>
            <pc:sldMk cId="2079782646" sldId="262"/>
            <ac:spMk id="3" creationId="{00000000-0000-0000-0000-000000000000}"/>
          </ac:spMkLst>
        </pc:spChg>
      </pc:sldChg>
      <pc:sldChg chg="addSp delSp modSp mod">
        <pc:chgData name="kenichiro otsuka" userId="99cd8c0872cf49df" providerId="LiveId" clId="{16396DD9-8CC4-3040-80AC-A46C47344420}" dt="2022-05-01T07:18:48.055" v="335" actId="113"/>
        <pc:sldMkLst>
          <pc:docMk/>
          <pc:sldMk cId="2883334632" sldId="263"/>
        </pc:sldMkLst>
        <pc:spChg chg="mod">
          <ac:chgData name="kenichiro otsuka" userId="99cd8c0872cf49df" providerId="LiveId" clId="{16396DD9-8CC4-3040-80AC-A46C47344420}" dt="2022-05-01T07:18:48.055" v="335" actId="113"/>
          <ac:spMkLst>
            <pc:docMk/>
            <pc:sldMk cId="2883334632" sldId="263"/>
            <ac:spMk id="2" creationId="{00000000-0000-0000-0000-000000000000}"/>
          </ac:spMkLst>
        </pc:spChg>
        <pc:spChg chg="del">
          <ac:chgData name="kenichiro otsuka" userId="99cd8c0872cf49df" providerId="LiveId" clId="{16396DD9-8CC4-3040-80AC-A46C47344420}" dt="2022-05-01T06:57:52.923" v="28" actId="478"/>
          <ac:spMkLst>
            <pc:docMk/>
            <pc:sldMk cId="2883334632" sldId="263"/>
            <ac:spMk id="3" creationId="{00000000-0000-0000-0000-000000000000}"/>
          </ac:spMkLst>
        </pc:spChg>
        <pc:spChg chg="add del mod">
          <ac:chgData name="kenichiro otsuka" userId="99cd8c0872cf49df" providerId="LiveId" clId="{16396DD9-8CC4-3040-80AC-A46C47344420}" dt="2022-05-01T06:58:47.890" v="66"/>
          <ac:spMkLst>
            <pc:docMk/>
            <pc:sldMk cId="2883334632" sldId="263"/>
            <ac:spMk id="9" creationId="{6828B593-89FB-BA8E-7E99-9D96E8011C21}"/>
          </ac:spMkLst>
        </pc:spChg>
      </pc:sldChg>
      <pc:sldChg chg="delSp modSp mod">
        <pc:chgData name="kenichiro otsuka" userId="99cd8c0872cf49df" providerId="LiveId" clId="{16396DD9-8CC4-3040-80AC-A46C47344420}" dt="2022-05-01T07:18:43.194" v="334" actId="113"/>
        <pc:sldMkLst>
          <pc:docMk/>
          <pc:sldMk cId="149728198" sldId="264"/>
        </pc:sldMkLst>
        <pc:spChg chg="mod">
          <ac:chgData name="kenichiro otsuka" userId="99cd8c0872cf49df" providerId="LiveId" clId="{16396DD9-8CC4-3040-80AC-A46C47344420}" dt="2022-05-01T07:18:43.194" v="334" actId="113"/>
          <ac:spMkLst>
            <pc:docMk/>
            <pc:sldMk cId="149728198" sldId="264"/>
            <ac:spMk id="2" creationId="{00000000-0000-0000-0000-000000000000}"/>
          </ac:spMkLst>
        </pc:spChg>
        <pc:spChg chg="del">
          <ac:chgData name="kenichiro otsuka" userId="99cd8c0872cf49df" providerId="LiveId" clId="{16396DD9-8CC4-3040-80AC-A46C47344420}" dt="2022-05-01T07:17:12.855" v="309" actId="478"/>
          <ac:spMkLst>
            <pc:docMk/>
            <pc:sldMk cId="149728198" sldId="264"/>
            <ac:spMk id="3" creationId="{00000000-0000-0000-0000-000000000000}"/>
          </ac:spMkLst>
        </pc:spChg>
        <pc:spChg chg="mod">
          <ac:chgData name="kenichiro otsuka" userId="99cd8c0872cf49df" providerId="LiveId" clId="{16396DD9-8CC4-3040-80AC-A46C47344420}" dt="2022-05-01T06:58:13.275" v="64" actId="20577"/>
          <ac:spMkLst>
            <pc:docMk/>
            <pc:sldMk cId="149728198" sldId="264"/>
            <ac:spMk id="5" creationId="{00000000-0000-0000-0000-000000000000}"/>
          </ac:spMkLst>
        </pc:spChg>
      </pc:sldChg>
      <pc:sldChg chg="modSp mod">
        <pc:chgData name="kenichiro otsuka" userId="99cd8c0872cf49df" providerId="LiveId" clId="{16396DD9-8CC4-3040-80AC-A46C47344420}" dt="2022-05-01T07:18:28.745" v="331" actId="113"/>
        <pc:sldMkLst>
          <pc:docMk/>
          <pc:sldMk cId="2946818097" sldId="265"/>
        </pc:sldMkLst>
        <pc:spChg chg="mod">
          <ac:chgData name="kenichiro otsuka" userId="99cd8c0872cf49df" providerId="LiveId" clId="{16396DD9-8CC4-3040-80AC-A46C47344420}" dt="2022-05-01T07:18:28.745" v="331" actId="113"/>
          <ac:spMkLst>
            <pc:docMk/>
            <pc:sldMk cId="2946818097" sldId="265"/>
            <ac:spMk id="2" creationId="{00000000-0000-0000-0000-000000000000}"/>
          </ac:spMkLst>
        </pc:spChg>
        <pc:spChg chg="mod">
          <ac:chgData name="kenichiro otsuka" userId="99cd8c0872cf49df" providerId="LiveId" clId="{16396DD9-8CC4-3040-80AC-A46C47344420}" dt="2022-05-01T07:11:49.344" v="147" actId="1076"/>
          <ac:spMkLst>
            <pc:docMk/>
            <pc:sldMk cId="2946818097" sldId="265"/>
            <ac:spMk id="3" creationId="{00000000-0000-0000-0000-000000000000}"/>
          </ac:spMkLst>
        </pc:spChg>
        <pc:spChg chg="mod">
          <ac:chgData name="kenichiro otsuka" userId="99cd8c0872cf49df" providerId="LiveId" clId="{16396DD9-8CC4-3040-80AC-A46C47344420}" dt="2022-05-01T07:18:02.567" v="328" actId="20577"/>
          <ac:spMkLst>
            <pc:docMk/>
            <pc:sldMk cId="2946818097" sldId="265"/>
            <ac:spMk id="5" creationId="{00000000-0000-0000-0000-000000000000}"/>
          </ac:spMkLst>
        </pc:spChg>
      </pc:sldChg>
      <pc:sldChg chg="addSp delSp modSp mod">
        <pc:chgData name="kenichiro otsuka" userId="99cd8c0872cf49df" providerId="LiveId" clId="{16396DD9-8CC4-3040-80AC-A46C47344420}" dt="2022-05-01T07:18:24.355" v="330" actId="113"/>
        <pc:sldMkLst>
          <pc:docMk/>
          <pc:sldMk cId="349600417" sldId="266"/>
        </pc:sldMkLst>
        <pc:spChg chg="mod">
          <ac:chgData name="kenichiro otsuka" userId="99cd8c0872cf49df" providerId="LiveId" clId="{16396DD9-8CC4-3040-80AC-A46C47344420}" dt="2022-05-01T07:18:24.355" v="330" actId="113"/>
          <ac:spMkLst>
            <pc:docMk/>
            <pc:sldMk cId="349600417" sldId="266"/>
            <ac:spMk id="2" creationId="{00000000-0000-0000-0000-000000000000}"/>
          </ac:spMkLst>
        </pc:spChg>
        <pc:spChg chg="del mod">
          <ac:chgData name="kenichiro otsuka" userId="99cd8c0872cf49df" providerId="LiveId" clId="{16396DD9-8CC4-3040-80AC-A46C47344420}" dt="2022-05-01T07:12:31.347" v="165" actId="478"/>
          <ac:spMkLst>
            <pc:docMk/>
            <pc:sldMk cId="349600417" sldId="266"/>
            <ac:spMk id="3" creationId="{00000000-0000-0000-0000-000000000000}"/>
          </ac:spMkLst>
        </pc:spChg>
        <pc:spChg chg="add del mod">
          <ac:chgData name="kenichiro otsuka" userId="99cd8c0872cf49df" providerId="LiveId" clId="{16396DD9-8CC4-3040-80AC-A46C47344420}" dt="2022-05-01T07:12:28.752" v="164" actId="478"/>
          <ac:spMkLst>
            <pc:docMk/>
            <pc:sldMk cId="349600417" sldId="266"/>
            <ac:spMk id="7" creationId="{5667E993-B9BC-0ECF-030C-DB44C255DF8C}"/>
          </ac:spMkLst>
        </pc:spChg>
        <pc:spChg chg="add mod">
          <ac:chgData name="kenichiro otsuka" userId="99cd8c0872cf49df" providerId="LiveId" clId="{16396DD9-8CC4-3040-80AC-A46C47344420}" dt="2022-05-01T07:14:00.665" v="180" actId="14100"/>
          <ac:spMkLst>
            <pc:docMk/>
            <pc:sldMk cId="349600417" sldId="266"/>
            <ac:spMk id="8" creationId="{79B02A3E-1CEB-7A2C-CFEC-9FC08391CEDD}"/>
          </ac:spMkLst>
        </pc:spChg>
      </pc:sldChg>
      <pc:sldChg chg="addSp delSp modSp mod">
        <pc:chgData name="kenichiro otsuka" userId="99cd8c0872cf49df" providerId="LiveId" clId="{16396DD9-8CC4-3040-80AC-A46C47344420}" dt="2022-05-01T07:18:19.560" v="329" actId="113"/>
        <pc:sldMkLst>
          <pc:docMk/>
          <pc:sldMk cId="1470050889" sldId="269"/>
        </pc:sldMkLst>
        <pc:spChg chg="mod">
          <ac:chgData name="kenichiro otsuka" userId="99cd8c0872cf49df" providerId="LiveId" clId="{16396DD9-8CC4-3040-80AC-A46C47344420}" dt="2022-05-01T07:18:19.560" v="329" actId="113"/>
          <ac:spMkLst>
            <pc:docMk/>
            <pc:sldMk cId="1470050889" sldId="269"/>
            <ac:spMk id="2" creationId="{00000000-0000-0000-0000-000000000000}"/>
          </ac:spMkLst>
        </pc:spChg>
        <pc:spChg chg="del">
          <ac:chgData name="kenichiro otsuka" userId="99cd8c0872cf49df" providerId="LiveId" clId="{16396DD9-8CC4-3040-80AC-A46C47344420}" dt="2022-05-01T07:14:09.503" v="182" actId="478"/>
          <ac:spMkLst>
            <pc:docMk/>
            <pc:sldMk cId="1470050889" sldId="269"/>
            <ac:spMk id="3" creationId="{00000000-0000-0000-0000-000000000000}"/>
          </ac:spMkLst>
        </pc:spChg>
        <pc:spChg chg="mod">
          <ac:chgData name="kenichiro otsuka" userId="99cd8c0872cf49df" providerId="LiveId" clId="{16396DD9-8CC4-3040-80AC-A46C47344420}" dt="2022-05-01T07:14:22.394" v="214" actId="20577"/>
          <ac:spMkLst>
            <pc:docMk/>
            <pc:sldMk cId="1470050889" sldId="269"/>
            <ac:spMk id="5" creationId="{00000000-0000-0000-0000-000000000000}"/>
          </ac:spMkLst>
        </pc:spChg>
        <pc:spChg chg="mod">
          <ac:chgData name="kenichiro otsuka" userId="99cd8c0872cf49df" providerId="LiveId" clId="{16396DD9-8CC4-3040-80AC-A46C47344420}" dt="2022-05-01T07:14:46.783" v="276" actId="27636"/>
          <ac:spMkLst>
            <pc:docMk/>
            <pc:sldMk cId="1470050889" sldId="269"/>
            <ac:spMk id="6" creationId="{00000000-0000-0000-0000-000000000000}"/>
          </ac:spMkLst>
        </pc:spChg>
        <pc:spChg chg="add mod">
          <ac:chgData name="kenichiro otsuka" userId="99cd8c0872cf49df" providerId="LiveId" clId="{16396DD9-8CC4-3040-80AC-A46C47344420}" dt="2022-05-01T07:14:15.043" v="183" actId="1076"/>
          <ac:spMkLst>
            <pc:docMk/>
            <pc:sldMk cId="1470050889" sldId="269"/>
            <ac:spMk id="9" creationId="{486DA07A-7E20-06C3-CABF-45C9A610885A}"/>
          </ac:spMkLst>
        </pc:spChg>
      </pc:sldChg>
      <pc:sldChg chg="addSp delSp modSp mod">
        <pc:chgData name="kenichiro otsuka" userId="99cd8c0872cf49df" providerId="LiveId" clId="{16396DD9-8CC4-3040-80AC-A46C47344420}" dt="2022-05-01T07:16:45.907" v="308" actId="27636"/>
        <pc:sldMkLst>
          <pc:docMk/>
          <pc:sldMk cId="2298962906" sldId="270"/>
        </pc:sldMkLst>
        <pc:spChg chg="del">
          <ac:chgData name="kenichiro otsuka" userId="99cd8c0872cf49df" providerId="LiveId" clId="{16396DD9-8CC4-3040-80AC-A46C47344420}" dt="2022-05-01T07:14:53.713" v="277" actId="478"/>
          <ac:spMkLst>
            <pc:docMk/>
            <pc:sldMk cId="2298962906" sldId="270"/>
            <ac:spMk id="5" creationId="{00000000-0000-0000-0000-000000000000}"/>
          </ac:spMkLst>
        </pc:spChg>
        <pc:spChg chg="add mod">
          <ac:chgData name="kenichiro otsuka" userId="99cd8c0872cf49df" providerId="LiveId" clId="{16396DD9-8CC4-3040-80AC-A46C47344420}" dt="2022-05-01T07:16:45.907" v="308" actId="27636"/>
          <ac:spMkLst>
            <pc:docMk/>
            <pc:sldMk cId="2298962906" sldId="270"/>
            <ac:spMk id="6" creationId="{13C14CE8-CAF4-0BCA-8D51-2B63CC9314CB}"/>
          </ac:spMkLst>
        </pc:spChg>
      </pc:sldChg>
      <pc:sldChg chg="addSp delSp modSp mod">
        <pc:chgData name="kenichiro otsuka" userId="99cd8c0872cf49df" providerId="LiveId" clId="{16396DD9-8CC4-3040-80AC-A46C47344420}" dt="2022-05-01T07:18:39.329" v="333" actId="113"/>
        <pc:sldMkLst>
          <pc:docMk/>
          <pc:sldMk cId="3540674453" sldId="271"/>
        </pc:sldMkLst>
        <pc:spChg chg="mod">
          <ac:chgData name="kenichiro otsuka" userId="99cd8c0872cf49df" providerId="LiveId" clId="{16396DD9-8CC4-3040-80AC-A46C47344420}" dt="2022-05-01T07:18:39.329" v="333" actId="113"/>
          <ac:spMkLst>
            <pc:docMk/>
            <pc:sldMk cId="3540674453" sldId="271"/>
            <ac:spMk id="2" creationId="{00000000-0000-0000-0000-000000000000}"/>
          </ac:spMkLst>
        </pc:spChg>
        <pc:spChg chg="del">
          <ac:chgData name="kenichiro otsuka" userId="99cd8c0872cf49df" providerId="LiveId" clId="{16396DD9-8CC4-3040-80AC-A46C47344420}" dt="2022-05-01T06:59:02.244" v="68" actId="478"/>
          <ac:spMkLst>
            <pc:docMk/>
            <pc:sldMk cId="3540674453" sldId="271"/>
            <ac:spMk id="3" creationId="{00000000-0000-0000-0000-000000000000}"/>
          </ac:spMkLst>
        </pc:spChg>
        <pc:spChg chg="add mod">
          <ac:chgData name="kenichiro otsuka" userId="99cd8c0872cf49df" providerId="LiveId" clId="{16396DD9-8CC4-3040-80AC-A46C47344420}" dt="2022-05-01T07:12:03.228" v="153" actId="20577"/>
          <ac:spMkLst>
            <pc:docMk/>
            <pc:sldMk cId="3540674453" sldId="271"/>
            <ac:spMk id="10" creationId="{AADFAA64-A5BB-7759-33EA-AA52CC2C2F75}"/>
          </ac:spMkLst>
        </pc:spChg>
      </pc:sldChg>
      <pc:sldChg chg="addSp delSp modSp mod">
        <pc:chgData name="kenichiro otsuka" userId="99cd8c0872cf49df" providerId="LiveId" clId="{16396DD9-8CC4-3040-80AC-A46C47344420}" dt="2022-05-01T07:18:34.240" v="332" actId="113"/>
        <pc:sldMkLst>
          <pc:docMk/>
          <pc:sldMk cId="3134786594" sldId="272"/>
        </pc:sldMkLst>
        <pc:spChg chg="mod">
          <ac:chgData name="kenichiro otsuka" userId="99cd8c0872cf49df" providerId="LiveId" clId="{16396DD9-8CC4-3040-80AC-A46C47344420}" dt="2022-05-01T07:18:34.240" v="332" actId="113"/>
          <ac:spMkLst>
            <pc:docMk/>
            <pc:sldMk cId="3134786594" sldId="272"/>
            <ac:spMk id="2" creationId="{00000000-0000-0000-0000-000000000000}"/>
          </ac:spMkLst>
        </pc:spChg>
        <pc:spChg chg="del">
          <ac:chgData name="kenichiro otsuka" userId="99cd8c0872cf49df" providerId="LiveId" clId="{16396DD9-8CC4-3040-80AC-A46C47344420}" dt="2022-05-01T06:59:40.170" v="125" actId="478"/>
          <ac:spMkLst>
            <pc:docMk/>
            <pc:sldMk cId="3134786594" sldId="272"/>
            <ac:spMk id="3" creationId="{00000000-0000-0000-0000-000000000000}"/>
          </ac:spMkLst>
        </pc:spChg>
        <pc:spChg chg="mod">
          <ac:chgData name="kenichiro otsuka" userId="99cd8c0872cf49df" providerId="LiveId" clId="{16396DD9-8CC4-3040-80AC-A46C47344420}" dt="2022-05-01T06:59:36.149" v="124" actId="20577"/>
          <ac:spMkLst>
            <pc:docMk/>
            <pc:sldMk cId="3134786594" sldId="272"/>
            <ac:spMk id="5" creationId="{00000000-0000-0000-0000-000000000000}"/>
          </ac:spMkLst>
        </pc:spChg>
        <pc:spChg chg="add del mod">
          <ac:chgData name="kenichiro otsuka" userId="99cd8c0872cf49df" providerId="LiveId" clId="{16396DD9-8CC4-3040-80AC-A46C47344420}" dt="2022-05-01T06:59:55.539" v="127"/>
          <ac:spMkLst>
            <pc:docMk/>
            <pc:sldMk cId="3134786594" sldId="272"/>
            <ac:spMk id="6" creationId="{48A981C2-D595-D0C4-CEFE-4DE9A0626E00}"/>
          </ac:spMkLst>
        </pc:spChg>
        <pc:spChg chg="add mod">
          <ac:chgData name="kenichiro otsuka" userId="99cd8c0872cf49df" providerId="LiveId" clId="{16396DD9-8CC4-3040-80AC-A46C47344420}" dt="2022-05-01T07:01:06.818" v="143" actId="1036"/>
          <ac:spMkLst>
            <pc:docMk/>
            <pc:sldMk cId="3134786594" sldId="272"/>
            <ac:spMk id="12" creationId="{276B6960-58A6-D3F0-5958-566CCA8B327F}"/>
          </ac:spMkLst>
        </pc:spChg>
      </pc:sldChg>
    </pc:docChg>
  </pc:docChgLst>
  <pc:docChgLst>
    <pc:chgData name="kenichiro otsuka" userId="99cd8c0872cf49df" providerId="LiveId" clId="{6674E44C-D0D6-1B45-B891-4FA54C88CA99}"/>
    <pc:docChg chg="undo custSel addSld delSld modSld">
      <pc:chgData name="kenichiro otsuka" userId="99cd8c0872cf49df" providerId="LiveId" clId="{6674E44C-D0D6-1B45-B891-4FA54C88CA99}" dt="2022-06-20T03:51:34.673" v="447" actId="14100"/>
      <pc:docMkLst>
        <pc:docMk/>
      </pc:docMkLst>
      <pc:sldChg chg="modSp mod">
        <pc:chgData name="kenichiro otsuka" userId="99cd8c0872cf49df" providerId="LiveId" clId="{6674E44C-D0D6-1B45-B891-4FA54C88CA99}" dt="2022-06-18T03:39:15.611" v="12" actId="20577"/>
        <pc:sldMkLst>
          <pc:docMk/>
          <pc:sldMk cId="1089892516" sldId="260"/>
        </pc:sldMkLst>
        <pc:spChg chg="mod">
          <ac:chgData name="kenichiro otsuka" userId="99cd8c0872cf49df" providerId="LiveId" clId="{6674E44C-D0D6-1B45-B891-4FA54C88CA99}" dt="2022-06-18T03:39:15.611" v="12" actId="20577"/>
          <ac:spMkLst>
            <pc:docMk/>
            <pc:sldMk cId="1089892516" sldId="260"/>
            <ac:spMk id="2" creationId="{00000000-0000-0000-0000-000000000000}"/>
          </ac:spMkLst>
        </pc:spChg>
      </pc:sldChg>
      <pc:sldChg chg="delSp modSp mod">
        <pc:chgData name="kenichiro otsuka" userId="99cd8c0872cf49df" providerId="LiveId" clId="{6674E44C-D0D6-1B45-B891-4FA54C88CA99}" dt="2022-06-20T03:50:31.128" v="440" actId="948"/>
        <pc:sldMkLst>
          <pc:docMk/>
          <pc:sldMk cId="2079782646" sldId="262"/>
        </pc:sldMkLst>
        <pc:spChg chg="del">
          <ac:chgData name="kenichiro otsuka" userId="99cd8c0872cf49df" providerId="LiveId" clId="{6674E44C-D0D6-1B45-B891-4FA54C88CA99}" dt="2022-06-18T03:42:40.543" v="20" actId="478"/>
          <ac:spMkLst>
            <pc:docMk/>
            <pc:sldMk cId="2079782646" sldId="262"/>
            <ac:spMk id="3" creationId="{00000000-0000-0000-0000-000000000000}"/>
          </ac:spMkLst>
        </pc:spChg>
        <pc:spChg chg="mod">
          <ac:chgData name="kenichiro otsuka" userId="99cd8c0872cf49df" providerId="LiveId" clId="{6674E44C-D0D6-1B45-B891-4FA54C88CA99}" dt="2022-06-20T03:50:31.128" v="440" actId="948"/>
          <ac:spMkLst>
            <pc:docMk/>
            <pc:sldMk cId="2079782646" sldId="262"/>
            <ac:spMk id="5" creationId="{00000000-0000-0000-0000-000000000000}"/>
          </ac:spMkLst>
        </pc:spChg>
      </pc:sldChg>
      <pc:sldChg chg="modSp mod">
        <pc:chgData name="kenichiro otsuka" userId="99cd8c0872cf49df" providerId="LiveId" clId="{6674E44C-D0D6-1B45-B891-4FA54C88CA99}" dt="2022-06-20T03:35:31.662" v="235" actId="1076"/>
        <pc:sldMkLst>
          <pc:docMk/>
          <pc:sldMk cId="2883334632" sldId="263"/>
        </pc:sldMkLst>
        <pc:spChg chg="mod">
          <ac:chgData name="kenichiro otsuka" userId="99cd8c0872cf49df" providerId="LiveId" clId="{6674E44C-D0D6-1B45-B891-4FA54C88CA99}" dt="2022-06-20T03:35:31.662" v="235" actId="1076"/>
          <ac:spMkLst>
            <pc:docMk/>
            <pc:sldMk cId="2883334632" sldId="263"/>
            <ac:spMk id="5" creationId="{00000000-0000-0000-0000-000000000000}"/>
          </ac:spMkLst>
        </pc:spChg>
        <pc:picChg chg="mod">
          <ac:chgData name="kenichiro otsuka" userId="99cd8c0872cf49df" providerId="LiveId" clId="{6674E44C-D0D6-1B45-B891-4FA54C88CA99}" dt="2022-06-20T03:35:18.686" v="233" actId="1076"/>
          <ac:picMkLst>
            <pc:docMk/>
            <pc:sldMk cId="2883334632" sldId="263"/>
            <ac:picMk id="7" creationId="{BEACB10E-2208-A548-952A-BE95080EC5B3}"/>
          </ac:picMkLst>
        </pc:picChg>
        <pc:picChg chg="mod">
          <ac:chgData name="kenichiro otsuka" userId="99cd8c0872cf49df" providerId="LiveId" clId="{6674E44C-D0D6-1B45-B891-4FA54C88CA99}" dt="2022-06-20T03:35:20.562" v="234" actId="1037"/>
          <ac:picMkLst>
            <pc:docMk/>
            <pc:sldMk cId="2883334632" sldId="263"/>
            <ac:picMk id="8" creationId="{F3A544D1-62E2-8847-8DC2-04E4E574370A}"/>
          </ac:picMkLst>
        </pc:picChg>
      </pc:sldChg>
      <pc:sldChg chg="delSp modSp mod">
        <pc:chgData name="kenichiro otsuka" userId="99cd8c0872cf49df" providerId="LiveId" clId="{6674E44C-D0D6-1B45-B891-4FA54C88CA99}" dt="2022-06-20T03:36:26.926" v="254" actId="478"/>
        <pc:sldMkLst>
          <pc:docMk/>
          <pc:sldMk cId="149728198" sldId="264"/>
        </pc:sldMkLst>
        <pc:spChg chg="mod">
          <ac:chgData name="kenichiro otsuka" userId="99cd8c0872cf49df" providerId="LiveId" clId="{6674E44C-D0D6-1B45-B891-4FA54C88CA99}" dt="2022-06-20T03:36:21.451" v="253" actId="20577"/>
          <ac:spMkLst>
            <pc:docMk/>
            <pc:sldMk cId="149728198" sldId="264"/>
            <ac:spMk id="5" creationId="{00000000-0000-0000-0000-000000000000}"/>
          </ac:spMkLst>
        </pc:spChg>
        <pc:spChg chg="del">
          <ac:chgData name="kenichiro otsuka" userId="99cd8c0872cf49df" providerId="LiveId" clId="{6674E44C-D0D6-1B45-B891-4FA54C88CA99}" dt="2022-06-20T03:36:26.926" v="254" actId="478"/>
          <ac:spMkLst>
            <pc:docMk/>
            <pc:sldMk cId="149728198" sldId="264"/>
            <ac:spMk id="6" creationId="{00000000-0000-0000-0000-000000000000}"/>
          </ac:spMkLst>
        </pc:spChg>
        <pc:picChg chg="mod">
          <ac:chgData name="kenichiro otsuka" userId="99cd8c0872cf49df" providerId="LiveId" clId="{6674E44C-D0D6-1B45-B891-4FA54C88CA99}" dt="2022-06-20T03:35:59.526" v="242" actId="1076"/>
          <ac:picMkLst>
            <pc:docMk/>
            <pc:sldMk cId="149728198" sldId="264"/>
            <ac:picMk id="7" creationId="{510D7216-571D-BB46-BEBB-5497998151D8}"/>
          </ac:picMkLst>
        </pc:picChg>
        <pc:picChg chg="mod">
          <ac:chgData name="kenichiro otsuka" userId="99cd8c0872cf49df" providerId="LiveId" clId="{6674E44C-D0D6-1B45-B891-4FA54C88CA99}" dt="2022-06-20T03:35:58.290" v="241" actId="1076"/>
          <ac:picMkLst>
            <pc:docMk/>
            <pc:sldMk cId="149728198" sldId="264"/>
            <ac:picMk id="8" creationId="{56A1F43D-A197-3C41-890E-5C47EDB546D1}"/>
          </ac:picMkLst>
        </pc:picChg>
      </pc:sldChg>
      <pc:sldChg chg="delSp modSp mod">
        <pc:chgData name="kenichiro otsuka" userId="99cd8c0872cf49df" providerId="LiveId" clId="{6674E44C-D0D6-1B45-B891-4FA54C88CA99}" dt="2022-06-20T03:38:10.271" v="318" actId="27636"/>
        <pc:sldMkLst>
          <pc:docMk/>
          <pc:sldMk cId="2946818097" sldId="265"/>
        </pc:sldMkLst>
        <pc:spChg chg="del">
          <ac:chgData name="kenichiro otsuka" userId="99cd8c0872cf49df" providerId="LiveId" clId="{6674E44C-D0D6-1B45-B891-4FA54C88CA99}" dt="2022-06-18T03:41:24.902" v="17" actId="478"/>
          <ac:spMkLst>
            <pc:docMk/>
            <pc:sldMk cId="2946818097" sldId="265"/>
            <ac:spMk id="3" creationId="{00000000-0000-0000-0000-000000000000}"/>
          </ac:spMkLst>
        </pc:spChg>
        <pc:spChg chg="mod">
          <ac:chgData name="kenichiro otsuka" userId="99cd8c0872cf49df" providerId="LiveId" clId="{6674E44C-D0D6-1B45-B891-4FA54C88CA99}" dt="2022-06-20T03:38:10.271" v="318" actId="27636"/>
          <ac:spMkLst>
            <pc:docMk/>
            <pc:sldMk cId="2946818097" sldId="265"/>
            <ac:spMk id="5" creationId="{00000000-0000-0000-0000-000000000000}"/>
          </ac:spMkLst>
        </pc:spChg>
      </pc:sldChg>
      <pc:sldChg chg="delSp modSp mod">
        <pc:chgData name="kenichiro otsuka" userId="99cd8c0872cf49df" providerId="LiveId" clId="{6674E44C-D0D6-1B45-B891-4FA54C88CA99}" dt="2022-06-20T03:51:34.673" v="447" actId="14100"/>
        <pc:sldMkLst>
          <pc:docMk/>
          <pc:sldMk cId="349600417" sldId="266"/>
        </pc:sldMkLst>
        <pc:spChg chg="mod">
          <ac:chgData name="kenichiro otsuka" userId="99cd8c0872cf49df" providerId="LiveId" clId="{6674E44C-D0D6-1B45-B891-4FA54C88CA99}" dt="2022-06-20T03:51:28.699" v="445" actId="14100"/>
          <ac:spMkLst>
            <pc:docMk/>
            <pc:sldMk cId="349600417" sldId="266"/>
            <ac:spMk id="5" creationId="{00000000-0000-0000-0000-000000000000}"/>
          </ac:spMkLst>
        </pc:spChg>
        <pc:spChg chg="mod">
          <ac:chgData name="kenichiro otsuka" userId="99cd8c0872cf49df" providerId="LiveId" clId="{6674E44C-D0D6-1B45-B891-4FA54C88CA99}" dt="2022-06-20T03:51:34.673" v="447" actId="14100"/>
          <ac:spMkLst>
            <pc:docMk/>
            <pc:sldMk cId="349600417" sldId="266"/>
            <ac:spMk id="6" creationId="{00000000-0000-0000-0000-000000000000}"/>
          </ac:spMkLst>
        </pc:spChg>
        <pc:spChg chg="del">
          <ac:chgData name="kenichiro otsuka" userId="99cd8c0872cf49df" providerId="LiveId" clId="{6674E44C-D0D6-1B45-B891-4FA54C88CA99}" dt="2022-06-18T03:41:29.767" v="18" actId="478"/>
          <ac:spMkLst>
            <pc:docMk/>
            <pc:sldMk cId="349600417" sldId="266"/>
            <ac:spMk id="8" creationId="{79B02A3E-1CEB-7A2C-CFEC-9FC08391CEDD}"/>
          </ac:spMkLst>
        </pc:spChg>
      </pc:sldChg>
      <pc:sldChg chg="addSp delSp modSp mod">
        <pc:chgData name="kenichiro otsuka" userId="99cd8c0872cf49df" providerId="LiveId" clId="{6674E44C-D0D6-1B45-B891-4FA54C88CA99}" dt="2022-06-20T03:44:54.576" v="410" actId="1076"/>
        <pc:sldMkLst>
          <pc:docMk/>
          <pc:sldMk cId="1470050889" sldId="269"/>
        </pc:sldMkLst>
        <pc:spChg chg="add mod">
          <ac:chgData name="kenichiro otsuka" userId="99cd8c0872cf49df" providerId="LiveId" clId="{6674E44C-D0D6-1B45-B891-4FA54C88CA99}" dt="2022-06-20T03:44:43.780" v="408" actId="1076"/>
          <ac:spMkLst>
            <pc:docMk/>
            <pc:sldMk cId="1470050889" sldId="269"/>
            <ac:spMk id="3" creationId="{638D4571-03F1-6989-6FCB-952297B57DAA}"/>
          </ac:spMkLst>
        </pc:spChg>
        <pc:spChg chg="mod">
          <ac:chgData name="kenichiro otsuka" userId="99cd8c0872cf49df" providerId="LiveId" clId="{6674E44C-D0D6-1B45-B891-4FA54C88CA99}" dt="2022-06-20T03:44:52.523" v="409" actId="1076"/>
          <ac:spMkLst>
            <pc:docMk/>
            <pc:sldMk cId="1470050889" sldId="269"/>
            <ac:spMk id="5" creationId="{00000000-0000-0000-0000-000000000000}"/>
          </ac:spMkLst>
        </pc:spChg>
        <pc:spChg chg="mod">
          <ac:chgData name="kenichiro otsuka" userId="99cd8c0872cf49df" providerId="LiveId" clId="{6674E44C-D0D6-1B45-B891-4FA54C88CA99}" dt="2022-06-20T03:44:54.576" v="410" actId="1076"/>
          <ac:spMkLst>
            <pc:docMk/>
            <pc:sldMk cId="1470050889" sldId="269"/>
            <ac:spMk id="6" creationId="{00000000-0000-0000-0000-000000000000}"/>
          </ac:spMkLst>
        </pc:spChg>
        <pc:spChg chg="mod">
          <ac:chgData name="kenichiro otsuka" userId="99cd8c0872cf49df" providerId="LiveId" clId="{6674E44C-D0D6-1B45-B891-4FA54C88CA99}" dt="2022-06-20T03:44:07.845" v="399" actId="1036"/>
          <ac:spMkLst>
            <pc:docMk/>
            <pc:sldMk cId="1470050889" sldId="269"/>
            <ac:spMk id="7" creationId="{00000000-0000-0000-0000-000000000000}"/>
          </ac:spMkLst>
        </pc:spChg>
        <pc:spChg chg="del">
          <ac:chgData name="kenichiro otsuka" userId="99cd8c0872cf49df" providerId="LiveId" clId="{6674E44C-D0D6-1B45-B891-4FA54C88CA99}" dt="2022-06-18T03:41:34.126" v="19" actId="478"/>
          <ac:spMkLst>
            <pc:docMk/>
            <pc:sldMk cId="1470050889" sldId="269"/>
            <ac:spMk id="9" creationId="{486DA07A-7E20-06C3-CABF-45C9A610885A}"/>
          </ac:spMkLst>
        </pc:spChg>
        <pc:picChg chg="add mod modCrop">
          <ac:chgData name="kenichiro otsuka" userId="99cd8c0872cf49df" providerId="LiveId" clId="{6674E44C-D0D6-1B45-B891-4FA54C88CA99}" dt="2022-06-20T03:44:29.314" v="405" actId="1076"/>
          <ac:picMkLst>
            <pc:docMk/>
            <pc:sldMk cId="1470050889" sldId="269"/>
            <ac:picMk id="8" creationId="{B4DA225A-F7D0-B6BF-62D1-DCF534B811A3}"/>
          </ac:picMkLst>
        </pc:picChg>
        <pc:picChg chg="add mod modCrop">
          <ac:chgData name="kenichiro otsuka" userId="99cd8c0872cf49df" providerId="LiveId" clId="{6674E44C-D0D6-1B45-B891-4FA54C88CA99}" dt="2022-06-20T03:44:27.150" v="404" actId="1076"/>
          <ac:picMkLst>
            <pc:docMk/>
            <pc:sldMk cId="1470050889" sldId="269"/>
            <ac:picMk id="9" creationId="{6D1F061A-EEE0-FE69-2EAE-D2254EC75937}"/>
          </ac:picMkLst>
        </pc:picChg>
        <pc:picChg chg="del mod">
          <ac:chgData name="kenichiro otsuka" userId="99cd8c0872cf49df" providerId="LiveId" clId="{6674E44C-D0D6-1B45-B891-4FA54C88CA99}" dt="2022-06-20T03:39:44.783" v="328" actId="478"/>
          <ac:picMkLst>
            <pc:docMk/>
            <pc:sldMk cId="1470050889" sldId="269"/>
            <ac:picMk id="10" creationId="{9AA7A7CE-8B36-EA06-C896-2395251B8DAA}"/>
          </ac:picMkLst>
        </pc:picChg>
      </pc:sldChg>
      <pc:sldChg chg="addSp delSp modSp mod">
        <pc:chgData name="kenichiro otsuka" userId="99cd8c0872cf49df" providerId="LiveId" clId="{6674E44C-D0D6-1B45-B891-4FA54C88CA99}" dt="2022-06-20T03:40:45.735" v="343" actId="113"/>
        <pc:sldMkLst>
          <pc:docMk/>
          <pc:sldMk cId="2298962906" sldId="270"/>
        </pc:sldMkLst>
        <pc:spChg chg="add mod">
          <ac:chgData name="kenichiro otsuka" userId="99cd8c0872cf49df" providerId="LiveId" clId="{6674E44C-D0D6-1B45-B891-4FA54C88CA99}" dt="2022-06-20T03:40:45.735" v="343" actId="113"/>
          <ac:spMkLst>
            <pc:docMk/>
            <pc:sldMk cId="2298962906" sldId="270"/>
            <ac:spMk id="5" creationId="{612B559E-E3A9-D381-F045-F23290DAB39D}"/>
          </ac:spMkLst>
        </pc:spChg>
        <pc:spChg chg="del">
          <ac:chgData name="kenichiro otsuka" userId="99cd8c0872cf49df" providerId="LiveId" clId="{6674E44C-D0D6-1B45-B891-4FA54C88CA99}" dt="2022-06-18T03:51:16.672" v="133" actId="478"/>
          <ac:spMkLst>
            <pc:docMk/>
            <pc:sldMk cId="2298962906" sldId="270"/>
            <ac:spMk id="6" creationId="{13C14CE8-CAF4-0BCA-8D51-2B63CC9314CB}"/>
          </ac:spMkLst>
        </pc:spChg>
        <pc:spChg chg="add mod">
          <ac:chgData name="kenichiro otsuka" userId="99cd8c0872cf49df" providerId="LiveId" clId="{6674E44C-D0D6-1B45-B891-4FA54C88CA99}" dt="2022-06-20T03:40:45.735" v="343" actId="113"/>
          <ac:spMkLst>
            <pc:docMk/>
            <pc:sldMk cId="2298962906" sldId="270"/>
            <ac:spMk id="6" creationId="{B15753D3-35C8-C16C-3F33-1E32856D3D2A}"/>
          </ac:spMkLst>
        </pc:spChg>
      </pc:sldChg>
      <pc:sldChg chg="addSp delSp modSp mod">
        <pc:chgData name="kenichiro otsuka" userId="99cd8c0872cf49df" providerId="LiveId" clId="{6674E44C-D0D6-1B45-B891-4FA54C88CA99}" dt="2022-06-20T03:37:16.758" v="280" actId="1076"/>
        <pc:sldMkLst>
          <pc:docMk/>
          <pc:sldMk cId="3540674453" sldId="271"/>
        </pc:sldMkLst>
        <pc:spChg chg="mod">
          <ac:chgData name="kenichiro otsuka" userId="99cd8c0872cf49df" providerId="LiveId" clId="{6674E44C-D0D6-1B45-B891-4FA54C88CA99}" dt="2022-06-20T03:37:13.604" v="279" actId="1076"/>
          <ac:spMkLst>
            <pc:docMk/>
            <pc:sldMk cId="3540674453" sldId="271"/>
            <ac:spMk id="5" creationId="{00000000-0000-0000-0000-000000000000}"/>
          </ac:spMkLst>
        </pc:spChg>
        <pc:spChg chg="add del">
          <ac:chgData name="kenichiro otsuka" userId="99cd8c0872cf49df" providerId="LiveId" clId="{6674E44C-D0D6-1B45-B891-4FA54C88CA99}" dt="2022-06-18T03:41:15.679" v="15" actId="478"/>
          <ac:spMkLst>
            <pc:docMk/>
            <pc:sldMk cId="3540674453" sldId="271"/>
            <ac:spMk id="10" creationId="{AADFAA64-A5BB-7759-33EA-AA52CC2C2F75}"/>
          </ac:spMkLst>
        </pc:spChg>
        <pc:picChg chg="mod">
          <ac:chgData name="kenichiro otsuka" userId="99cd8c0872cf49df" providerId="LiveId" clId="{6674E44C-D0D6-1B45-B891-4FA54C88CA99}" dt="2022-06-20T03:37:16.758" v="280" actId="1076"/>
          <ac:picMkLst>
            <pc:docMk/>
            <pc:sldMk cId="3540674453" sldId="271"/>
            <ac:picMk id="8" creationId="{B51E18CA-5660-D940-BE34-F8EAEFBD9919}"/>
          </ac:picMkLst>
        </pc:picChg>
      </pc:sldChg>
      <pc:sldChg chg="delSp modSp mod">
        <pc:chgData name="kenichiro otsuka" userId="99cd8c0872cf49df" providerId="LiveId" clId="{6674E44C-D0D6-1B45-B891-4FA54C88CA99}" dt="2022-06-20T03:50:56.848" v="443" actId="14100"/>
        <pc:sldMkLst>
          <pc:docMk/>
          <pc:sldMk cId="3134786594" sldId="272"/>
        </pc:sldMkLst>
        <pc:spChg chg="mod">
          <ac:chgData name="kenichiro otsuka" userId="99cd8c0872cf49df" providerId="LiveId" clId="{6674E44C-D0D6-1B45-B891-4FA54C88CA99}" dt="2022-06-20T03:50:56.848" v="443" actId="14100"/>
          <ac:spMkLst>
            <pc:docMk/>
            <pc:sldMk cId="3134786594" sldId="272"/>
            <ac:spMk id="5" creationId="{00000000-0000-0000-0000-000000000000}"/>
          </ac:spMkLst>
        </pc:spChg>
        <pc:spChg chg="del">
          <ac:chgData name="kenichiro otsuka" userId="99cd8c0872cf49df" providerId="LiveId" clId="{6674E44C-D0D6-1B45-B891-4FA54C88CA99}" dt="2022-06-18T03:41:19.632" v="16" actId="478"/>
          <ac:spMkLst>
            <pc:docMk/>
            <pc:sldMk cId="3134786594" sldId="272"/>
            <ac:spMk id="12" creationId="{276B6960-58A6-D3F0-5958-566CCA8B327F}"/>
          </ac:spMkLst>
        </pc:spChg>
        <pc:picChg chg="mod">
          <ac:chgData name="kenichiro otsuka" userId="99cd8c0872cf49df" providerId="LiveId" clId="{6674E44C-D0D6-1B45-B891-4FA54C88CA99}" dt="2022-06-20T03:50:53.729" v="442" actId="14100"/>
          <ac:picMkLst>
            <pc:docMk/>
            <pc:sldMk cId="3134786594" sldId="272"/>
            <ac:picMk id="7" creationId="{31616EF6-1CB4-4F48-1395-0F19AB8D5924}"/>
          </ac:picMkLst>
        </pc:picChg>
        <pc:picChg chg="mod">
          <ac:chgData name="kenichiro otsuka" userId="99cd8c0872cf49df" providerId="LiveId" clId="{6674E44C-D0D6-1B45-B891-4FA54C88CA99}" dt="2022-06-20T03:41:13.929" v="348" actId="1035"/>
          <ac:picMkLst>
            <pc:docMk/>
            <pc:sldMk cId="3134786594" sldId="272"/>
            <ac:picMk id="10" creationId="{CAC09AF5-CAA8-8342-837A-A91C15421D78}"/>
          </ac:picMkLst>
        </pc:picChg>
        <pc:picChg chg="mod">
          <ac:chgData name="kenichiro otsuka" userId="99cd8c0872cf49df" providerId="LiveId" clId="{6674E44C-D0D6-1B45-B891-4FA54C88CA99}" dt="2022-06-20T03:41:12.336" v="347" actId="1076"/>
          <ac:picMkLst>
            <pc:docMk/>
            <pc:sldMk cId="3134786594" sldId="272"/>
            <ac:picMk id="11" creationId="{F696DDF6-493E-6549-A01A-46B67A4FE511}"/>
          </ac:picMkLst>
        </pc:picChg>
      </pc:sldChg>
      <pc:sldChg chg="modSp add mod">
        <pc:chgData name="kenichiro otsuka" userId="99cd8c0872cf49df" providerId="LiveId" clId="{6674E44C-D0D6-1B45-B891-4FA54C88CA99}" dt="2022-06-20T03:42:37.937" v="351" actId="20577"/>
        <pc:sldMkLst>
          <pc:docMk/>
          <pc:sldMk cId="256979049" sldId="273"/>
        </pc:sldMkLst>
        <pc:spChg chg="mod">
          <ac:chgData name="kenichiro otsuka" userId="99cd8c0872cf49df" providerId="LiveId" clId="{6674E44C-D0D6-1B45-B891-4FA54C88CA99}" dt="2022-06-20T03:42:37.937" v="351" actId="20577"/>
          <ac:spMkLst>
            <pc:docMk/>
            <pc:sldMk cId="256979049" sldId="273"/>
            <ac:spMk id="5" creationId="{00000000-0000-0000-0000-000000000000}"/>
          </ac:spMkLst>
        </pc:spChg>
      </pc:sldChg>
      <pc:sldChg chg="addSp delSp modSp add del mod">
        <pc:chgData name="kenichiro otsuka" userId="99cd8c0872cf49df" providerId="LiveId" clId="{6674E44C-D0D6-1B45-B891-4FA54C88CA99}" dt="2022-06-20T03:32:39.989" v="189" actId="2696"/>
        <pc:sldMkLst>
          <pc:docMk/>
          <pc:sldMk cId="1458534341" sldId="273"/>
        </pc:sldMkLst>
        <pc:spChg chg="add mod">
          <ac:chgData name="kenichiro otsuka" userId="99cd8c0872cf49df" providerId="LiveId" clId="{6674E44C-D0D6-1B45-B891-4FA54C88CA99}" dt="2022-06-20T03:30:46.008" v="156" actId="20577"/>
          <ac:spMkLst>
            <pc:docMk/>
            <pc:sldMk cId="1458534341" sldId="273"/>
            <ac:spMk id="5" creationId="{ABCBEA5D-8FA6-CEC7-A3EE-3950F93EC7DC}"/>
          </ac:spMkLst>
        </pc:spChg>
        <pc:spChg chg="del">
          <ac:chgData name="kenichiro otsuka" userId="99cd8c0872cf49df" providerId="LiveId" clId="{6674E44C-D0D6-1B45-B891-4FA54C88CA99}" dt="2022-06-18T03:51:20.569" v="134" actId="478"/>
          <ac:spMkLst>
            <pc:docMk/>
            <pc:sldMk cId="1458534341" sldId="273"/>
            <ac:spMk id="6" creationId="{13C14CE8-CAF4-0BCA-8D51-2B63CC9314CB}"/>
          </ac:spMkLst>
        </pc:spChg>
      </pc:sldChg>
    </pc:docChg>
  </pc:docChgLst>
  <pc:docChgLst>
    <pc:chgData name="kenichiro otsuka" userId="99cd8c0872cf49df" providerId="LiveId" clId="{AF851DEA-67F2-BA47-8DF6-D3B416D6B570}"/>
    <pc:docChg chg="custSel addSld delSld modSld sldOrd">
      <pc:chgData name="kenichiro otsuka" userId="99cd8c0872cf49df" providerId="LiveId" clId="{AF851DEA-67F2-BA47-8DF6-D3B416D6B570}" dt="2021-11-22T01:38:39.495" v="525" actId="27636"/>
      <pc:docMkLst>
        <pc:docMk/>
      </pc:docMkLst>
      <pc:sldChg chg="addSp modSp mod">
        <pc:chgData name="kenichiro otsuka" userId="99cd8c0872cf49df" providerId="LiveId" clId="{AF851DEA-67F2-BA47-8DF6-D3B416D6B570}" dt="2021-11-22T00:16:53.410" v="209" actId="27636"/>
        <pc:sldMkLst>
          <pc:docMk/>
          <pc:sldMk cId="1089892516" sldId="260"/>
        </pc:sldMkLst>
        <pc:spChg chg="mod">
          <ac:chgData name="kenichiro otsuka" userId="99cd8c0872cf49df" providerId="LiveId" clId="{AF851DEA-67F2-BA47-8DF6-D3B416D6B570}" dt="2021-11-22T00:16:52.673" v="207" actId="1076"/>
          <ac:spMkLst>
            <pc:docMk/>
            <pc:sldMk cId="1089892516" sldId="260"/>
            <ac:spMk id="2" creationId="{00000000-0000-0000-0000-000000000000}"/>
          </ac:spMkLst>
        </pc:spChg>
        <pc:spChg chg="mod">
          <ac:chgData name="kenichiro otsuka" userId="99cd8c0872cf49df" providerId="LiveId" clId="{AF851DEA-67F2-BA47-8DF6-D3B416D6B570}" dt="2021-11-22T00:05:22.366" v="30" actId="20577"/>
          <ac:spMkLst>
            <pc:docMk/>
            <pc:sldMk cId="1089892516" sldId="260"/>
            <ac:spMk id="3" creationId="{00000000-0000-0000-0000-000000000000}"/>
          </ac:spMkLst>
        </pc:spChg>
        <pc:spChg chg="mod">
          <ac:chgData name="kenichiro otsuka" userId="99cd8c0872cf49df" providerId="LiveId" clId="{AF851DEA-67F2-BA47-8DF6-D3B416D6B570}" dt="2021-11-22T00:05:08.610" v="19" actId="20577"/>
          <ac:spMkLst>
            <pc:docMk/>
            <pc:sldMk cId="1089892516" sldId="260"/>
            <ac:spMk id="4" creationId="{00000000-0000-0000-0000-000000000000}"/>
          </ac:spMkLst>
        </pc:spChg>
        <pc:spChg chg="add mod">
          <ac:chgData name="kenichiro otsuka" userId="99cd8c0872cf49df" providerId="LiveId" clId="{AF851DEA-67F2-BA47-8DF6-D3B416D6B570}" dt="2021-11-22T00:16:53.410" v="209" actId="27636"/>
          <ac:spMkLst>
            <pc:docMk/>
            <pc:sldMk cId="1089892516" sldId="260"/>
            <ac:spMk id="5" creationId="{D57B4312-A014-B947-AE9E-90F90909AF08}"/>
          </ac:spMkLst>
        </pc:spChg>
      </pc:sldChg>
      <pc:sldChg chg="modSp mod">
        <pc:chgData name="kenichiro otsuka" userId="99cd8c0872cf49df" providerId="LiveId" clId="{AF851DEA-67F2-BA47-8DF6-D3B416D6B570}" dt="2021-11-22T01:28:16.565" v="438"/>
        <pc:sldMkLst>
          <pc:docMk/>
          <pc:sldMk cId="2079782646" sldId="262"/>
        </pc:sldMkLst>
        <pc:spChg chg="mod">
          <ac:chgData name="kenichiro otsuka" userId="99cd8c0872cf49df" providerId="LiveId" clId="{AF851DEA-67F2-BA47-8DF6-D3B416D6B570}" dt="2021-11-22T01:28:16.565" v="438"/>
          <ac:spMkLst>
            <pc:docMk/>
            <pc:sldMk cId="2079782646" sldId="262"/>
            <ac:spMk id="5" creationId="{00000000-0000-0000-0000-000000000000}"/>
          </ac:spMkLst>
        </pc:spChg>
      </pc:sldChg>
      <pc:sldChg chg="addSp delSp modSp mod">
        <pc:chgData name="kenichiro otsuka" userId="99cd8c0872cf49df" providerId="LiveId" clId="{AF851DEA-67F2-BA47-8DF6-D3B416D6B570}" dt="2021-11-22T00:15:16.484" v="192" actId="1076"/>
        <pc:sldMkLst>
          <pc:docMk/>
          <pc:sldMk cId="2883334632" sldId="263"/>
        </pc:sldMkLst>
        <pc:spChg chg="mod">
          <ac:chgData name="kenichiro otsuka" userId="99cd8c0872cf49df" providerId="LiveId" clId="{AF851DEA-67F2-BA47-8DF6-D3B416D6B570}" dt="2021-11-22T00:08:55.344" v="129" actId="20577"/>
          <ac:spMkLst>
            <pc:docMk/>
            <pc:sldMk cId="2883334632" sldId="263"/>
            <ac:spMk id="5" creationId="{00000000-0000-0000-0000-000000000000}"/>
          </ac:spMkLst>
        </pc:spChg>
        <pc:spChg chg="del mod">
          <ac:chgData name="kenichiro otsuka" userId="99cd8c0872cf49df" providerId="LiveId" clId="{AF851DEA-67F2-BA47-8DF6-D3B416D6B570}" dt="2021-11-22T00:14:46.500" v="183" actId="478"/>
          <ac:spMkLst>
            <pc:docMk/>
            <pc:sldMk cId="2883334632" sldId="263"/>
            <ac:spMk id="9" creationId="{EB7290F1-38F1-7E43-B2B0-E72DE54F35F4}"/>
          </ac:spMkLst>
        </pc:spChg>
        <pc:grpChg chg="add del mod">
          <ac:chgData name="kenichiro otsuka" userId="99cd8c0872cf49df" providerId="LiveId" clId="{AF851DEA-67F2-BA47-8DF6-D3B416D6B570}" dt="2021-11-22T00:14:53.620" v="185" actId="165"/>
          <ac:grpSpMkLst>
            <pc:docMk/>
            <pc:sldMk cId="2883334632" sldId="263"/>
            <ac:grpSpMk id="6" creationId="{5CD99F22-D45F-9B4C-A741-431DA31C438B}"/>
          </ac:grpSpMkLst>
        </pc:grpChg>
        <pc:picChg chg="mod topLvl">
          <ac:chgData name="kenichiro otsuka" userId="99cd8c0872cf49df" providerId="LiveId" clId="{AF851DEA-67F2-BA47-8DF6-D3B416D6B570}" dt="2021-11-22T00:15:16.484" v="192" actId="1076"/>
          <ac:picMkLst>
            <pc:docMk/>
            <pc:sldMk cId="2883334632" sldId="263"/>
            <ac:picMk id="7" creationId="{BEACB10E-2208-A548-952A-BE95080EC5B3}"/>
          </ac:picMkLst>
        </pc:picChg>
        <pc:picChg chg="mod topLvl">
          <ac:chgData name="kenichiro otsuka" userId="99cd8c0872cf49df" providerId="LiveId" clId="{AF851DEA-67F2-BA47-8DF6-D3B416D6B570}" dt="2021-11-22T00:15:16.484" v="192" actId="1076"/>
          <ac:picMkLst>
            <pc:docMk/>
            <pc:sldMk cId="2883334632" sldId="263"/>
            <ac:picMk id="8" creationId="{F3A544D1-62E2-8847-8DC2-04E4E574370A}"/>
          </ac:picMkLst>
        </pc:picChg>
      </pc:sldChg>
      <pc:sldChg chg="addSp modSp mod">
        <pc:chgData name="kenichiro otsuka" userId="99cd8c0872cf49df" providerId="LiveId" clId="{AF851DEA-67F2-BA47-8DF6-D3B416D6B570}" dt="2021-11-22T00:12:15.254" v="154" actId="27636"/>
        <pc:sldMkLst>
          <pc:docMk/>
          <pc:sldMk cId="149728198" sldId="264"/>
        </pc:sldMkLst>
        <pc:spChg chg="mod">
          <ac:chgData name="kenichiro otsuka" userId="99cd8c0872cf49df" providerId="LiveId" clId="{AF851DEA-67F2-BA47-8DF6-D3B416D6B570}" dt="2021-11-22T00:12:15.254" v="154" actId="27636"/>
          <ac:spMkLst>
            <pc:docMk/>
            <pc:sldMk cId="149728198" sldId="264"/>
            <ac:spMk id="5" creationId="{00000000-0000-0000-0000-000000000000}"/>
          </ac:spMkLst>
        </pc:spChg>
        <pc:spChg chg="mod">
          <ac:chgData name="kenichiro otsuka" userId="99cd8c0872cf49df" providerId="LiveId" clId="{AF851DEA-67F2-BA47-8DF6-D3B416D6B570}" dt="2021-11-22T00:10:32.093" v="132" actId="27636"/>
          <ac:spMkLst>
            <pc:docMk/>
            <pc:sldMk cId="149728198" sldId="264"/>
            <ac:spMk id="6" creationId="{00000000-0000-0000-0000-000000000000}"/>
          </ac:spMkLst>
        </pc:spChg>
        <pc:picChg chg="add mod">
          <ac:chgData name="kenichiro otsuka" userId="99cd8c0872cf49df" providerId="LiveId" clId="{AF851DEA-67F2-BA47-8DF6-D3B416D6B570}" dt="2021-11-22T00:10:51.299" v="135" actId="1076"/>
          <ac:picMkLst>
            <pc:docMk/>
            <pc:sldMk cId="149728198" sldId="264"/>
            <ac:picMk id="7" creationId="{510D7216-571D-BB46-BEBB-5497998151D8}"/>
          </ac:picMkLst>
        </pc:picChg>
        <pc:picChg chg="add mod">
          <ac:chgData name="kenichiro otsuka" userId="99cd8c0872cf49df" providerId="LiveId" clId="{AF851DEA-67F2-BA47-8DF6-D3B416D6B570}" dt="2021-11-22T00:10:51.299" v="135" actId="1076"/>
          <ac:picMkLst>
            <pc:docMk/>
            <pc:sldMk cId="149728198" sldId="264"/>
            <ac:picMk id="8" creationId="{56A1F43D-A197-3C41-890E-5C47EDB546D1}"/>
          </ac:picMkLst>
        </pc:picChg>
      </pc:sldChg>
      <pc:sldChg chg="modSp mod ord">
        <pc:chgData name="kenichiro otsuka" userId="99cd8c0872cf49df" providerId="LiveId" clId="{AF851DEA-67F2-BA47-8DF6-D3B416D6B570}" dt="2021-11-22T00:19:35.101" v="309" actId="20577"/>
        <pc:sldMkLst>
          <pc:docMk/>
          <pc:sldMk cId="2946818097" sldId="265"/>
        </pc:sldMkLst>
        <pc:spChg chg="mod">
          <ac:chgData name="kenichiro otsuka" userId="99cd8c0872cf49df" providerId="LiveId" clId="{AF851DEA-67F2-BA47-8DF6-D3B416D6B570}" dt="2021-11-22T00:19:35.101" v="309" actId="20577"/>
          <ac:spMkLst>
            <pc:docMk/>
            <pc:sldMk cId="2946818097" sldId="265"/>
            <ac:spMk id="5" creationId="{00000000-0000-0000-0000-000000000000}"/>
          </ac:spMkLst>
        </pc:spChg>
      </pc:sldChg>
      <pc:sldChg chg="modSp mod ord">
        <pc:chgData name="kenichiro otsuka" userId="99cd8c0872cf49df" providerId="LiveId" clId="{AF851DEA-67F2-BA47-8DF6-D3B416D6B570}" dt="2021-11-22T00:20:07.714" v="312" actId="20577"/>
        <pc:sldMkLst>
          <pc:docMk/>
          <pc:sldMk cId="349600417" sldId="266"/>
        </pc:sldMkLst>
        <pc:spChg chg="mod">
          <ac:chgData name="kenichiro otsuka" userId="99cd8c0872cf49df" providerId="LiveId" clId="{AF851DEA-67F2-BA47-8DF6-D3B416D6B570}" dt="2021-11-22T00:20:05.801" v="311" actId="27636"/>
          <ac:spMkLst>
            <pc:docMk/>
            <pc:sldMk cId="349600417" sldId="266"/>
            <ac:spMk id="5" creationId="{00000000-0000-0000-0000-000000000000}"/>
          </ac:spMkLst>
        </pc:spChg>
        <pc:spChg chg="mod">
          <ac:chgData name="kenichiro otsuka" userId="99cd8c0872cf49df" providerId="LiveId" clId="{AF851DEA-67F2-BA47-8DF6-D3B416D6B570}" dt="2021-11-22T00:20:07.714" v="312" actId="20577"/>
          <ac:spMkLst>
            <pc:docMk/>
            <pc:sldMk cId="349600417" sldId="266"/>
            <ac:spMk id="6" creationId="{00000000-0000-0000-0000-000000000000}"/>
          </ac:spMkLst>
        </pc:spChg>
      </pc:sldChg>
      <pc:sldChg chg="del">
        <pc:chgData name="kenichiro otsuka" userId="99cd8c0872cf49df" providerId="LiveId" clId="{AF851DEA-67F2-BA47-8DF6-D3B416D6B570}" dt="2021-11-22T00:16:26.049" v="204" actId="2696"/>
        <pc:sldMkLst>
          <pc:docMk/>
          <pc:sldMk cId="1514158967" sldId="267"/>
        </pc:sldMkLst>
      </pc:sldChg>
      <pc:sldChg chg="addSp delSp modSp mod ord">
        <pc:chgData name="kenichiro otsuka" userId="99cd8c0872cf49df" providerId="LiveId" clId="{AF851DEA-67F2-BA47-8DF6-D3B416D6B570}" dt="2021-11-22T01:38:39.495" v="525" actId="27636"/>
        <pc:sldMkLst>
          <pc:docMk/>
          <pc:sldMk cId="1470050889" sldId="269"/>
        </pc:sldMkLst>
        <pc:spChg chg="mod">
          <ac:chgData name="kenichiro otsuka" userId="99cd8c0872cf49df" providerId="LiveId" clId="{AF851DEA-67F2-BA47-8DF6-D3B416D6B570}" dt="2021-11-22T01:38:19.873" v="521" actId="27636"/>
          <ac:spMkLst>
            <pc:docMk/>
            <pc:sldMk cId="1470050889" sldId="269"/>
            <ac:spMk id="5" creationId="{00000000-0000-0000-0000-000000000000}"/>
          </ac:spMkLst>
        </pc:spChg>
        <pc:spChg chg="mod">
          <ac:chgData name="kenichiro otsuka" userId="99cd8c0872cf49df" providerId="LiveId" clId="{AF851DEA-67F2-BA47-8DF6-D3B416D6B570}" dt="2021-11-22T01:38:31.021" v="523" actId="27636"/>
          <ac:spMkLst>
            <pc:docMk/>
            <pc:sldMk cId="1470050889" sldId="269"/>
            <ac:spMk id="6" creationId="{00000000-0000-0000-0000-000000000000}"/>
          </ac:spMkLst>
        </pc:spChg>
        <pc:spChg chg="mod">
          <ac:chgData name="kenichiro otsuka" userId="99cd8c0872cf49df" providerId="LiveId" clId="{AF851DEA-67F2-BA47-8DF6-D3B416D6B570}" dt="2021-11-22T01:38:39.495" v="525" actId="27636"/>
          <ac:spMkLst>
            <pc:docMk/>
            <pc:sldMk cId="1470050889" sldId="269"/>
            <ac:spMk id="7" creationId="{00000000-0000-0000-0000-000000000000}"/>
          </ac:spMkLst>
        </pc:spChg>
        <pc:spChg chg="add del mod">
          <ac:chgData name="kenichiro otsuka" userId="99cd8c0872cf49df" providerId="LiveId" clId="{AF851DEA-67F2-BA47-8DF6-D3B416D6B570}" dt="2021-11-22T00:26:19.205" v="314" actId="478"/>
          <ac:spMkLst>
            <pc:docMk/>
            <pc:sldMk cId="1470050889" sldId="269"/>
            <ac:spMk id="10" creationId="{E2A67573-2729-D941-9757-01896038B97E}"/>
          </ac:spMkLst>
        </pc:spChg>
        <pc:spChg chg="add mod">
          <ac:chgData name="kenichiro otsuka" userId="99cd8c0872cf49df" providerId="LiveId" clId="{AF851DEA-67F2-BA47-8DF6-D3B416D6B570}" dt="2021-11-22T00:29:22.272" v="414" actId="478"/>
          <ac:spMkLst>
            <pc:docMk/>
            <pc:sldMk cId="1470050889" sldId="269"/>
            <ac:spMk id="14" creationId="{0CF276F1-ED10-3441-B0C6-0041B81C54AE}"/>
          </ac:spMkLst>
        </pc:spChg>
        <pc:picChg chg="del">
          <ac:chgData name="kenichiro otsuka" userId="99cd8c0872cf49df" providerId="LiveId" clId="{AF851DEA-67F2-BA47-8DF6-D3B416D6B570}" dt="2021-11-22T00:29:22.272" v="414" actId="478"/>
          <ac:picMkLst>
            <pc:docMk/>
            <pc:sldMk cId="1470050889" sldId="269"/>
            <ac:picMk id="12" creationId="{36F32474-D26D-7A40-B449-910EA74064CF}"/>
          </ac:picMkLst>
        </pc:picChg>
        <pc:picChg chg="del">
          <ac:chgData name="kenichiro otsuka" userId="99cd8c0872cf49df" providerId="LiveId" clId="{AF851DEA-67F2-BA47-8DF6-D3B416D6B570}" dt="2021-11-22T00:26:17.014" v="313" actId="478"/>
          <ac:picMkLst>
            <pc:docMk/>
            <pc:sldMk cId="1470050889" sldId="269"/>
            <ac:picMk id="13" creationId="{18C4E04B-F007-CE46-A96A-406B9CA7B4DC}"/>
          </ac:picMkLst>
        </pc:picChg>
      </pc:sldChg>
      <pc:sldChg chg="ord">
        <pc:chgData name="kenichiro otsuka" userId="99cd8c0872cf49df" providerId="LiveId" clId="{AF851DEA-67F2-BA47-8DF6-D3B416D6B570}" dt="2021-11-22T00:16:20.281" v="202" actId="20578"/>
        <pc:sldMkLst>
          <pc:docMk/>
          <pc:sldMk cId="2298962906" sldId="270"/>
        </pc:sldMkLst>
      </pc:sldChg>
      <pc:sldChg chg="addSp delSp modSp add mod ord">
        <pc:chgData name="kenichiro otsuka" userId="99cd8c0872cf49df" providerId="LiveId" clId="{AF851DEA-67F2-BA47-8DF6-D3B416D6B570}" dt="2021-11-22T01:29:34.752" v="453" actId="1076"/>
        <pc:sldMkLst>
          <pc:docMk/>
          <pc:sldMk cId="3540674453" sldId="271"/>
        </pc:sldMkLst>
        <pc:spChg chg="mod">
          <ac:chgData name="kenichiro otsuka" userId="99cd8c0872cf49df" providerId="LiveId" clId="{AF851DEA-67F2-BA47-8DF6-D3B416D6B570}" dt="2021-11-22T01:29:29.024" v="451" actId="27636"/>
          <ac:spMkLst>
            <pc:docMk/>
            <pc:sldMk cId="3540674453" sldId="271"/>
            <ac:spMk id="5" creationId="{00000000-0000-0000-0000-000000000000}"/>
          </ac:spMkLst>
        </pc:spChg>
        <pc:spChg chg="del mod">
          <ac:chgData name="kenichiro otsuka" userId="99cd8c0872cf49df" providerId="LiveId" clId="{AF851DEA-67F2-BA47-8DF6-D3B416D6B570}" dt="2021-11-22T00:13:00.709" v="161" actId="478"/>
          <ac:spMkLst>
            <pc:docMk/>
            <pc:sldMk cId="3540674453" sldId="271"/>
            <ac:spMk id="6" creationId="{00000000-0000-0000-0000-000000000000}"/>
          </ac:spMkLst>
        </pc:spChg>
        <pc:picChg chg="add del mod">
          <ac:chgData name="kenichiro otsuka" userId="99cd8c0872cf49df" providerId="LiveId" clId="{AF851DEA-67F2-BA47-8DF6-D3B416D6B570}" dt="2021-11-22T00:13:46.078" v="172" actId="478"/>
          <ac:picMkLst>
            <pc:docMk/>
            <pc:sldMk cId="3540674453" sldId="271"/>
            <ac:picMk id="7" creationId="{11F8763E-8AC4-8448-A5E2-EA49ABB58E02}"/>
          </ac:picMkLst>
        </pc:picChg>
        <pc:picChg chg="add mod">
          <ac:chgData name="kenichiro otsuka" userId="99cd8c0872cf49df" providerId="LiveId" clId="{AF851DEA-67F2-BA47-8DF6-D3B416D6B570}" dt="2021-11-22T01:29:32.885" v="452" actId="1076"/>
          <ac:picMkLst>
            <pc:docMk/>
            <pc:sldMk cId="3540674453" sldId="271"/>
            <ac:picMk id="8" creationId="{B51E18CA-5660-D940-BE34-F8EAEFBD9919}"/>
          </ac:picMkLst>
        </pc:picChg>
        <pc:picChg chg="add mod">
          <ac:chgData name="kenichiro otsuka" userId="99cd8c0872cf49df" providerId="LiveId" clId="{AF851DEA-67F2-BA47-8DF6-D3B416D6B570}" dt="2021-11-22T01:29:34.752" v="453" actId="1076"/>
          <ac:picMkLst>
            <pc:docMk/>
            <pc:sldMk cId="3540674453" sldId="271"/>
            <ac:picMk id="9" creationId="{5AB04E7A-7BDF-6941-B96B-5C8D6483986A}"/>
          </ac:picMkLst>
        </pc:picChg>
      </pc:sldChg>
      <pc:sldChg chg="new del ord">
        <pc:chgData name="kenichiro otsuka" userId="99cd8c0872cf49df" providerId="LiveId" clId="{AF851DEA-67F2-BA47-8DF6-D3B416D6B570}" dt="2021-11-22T00:16:27.109" v="205" actId="2696"/>
        <pc:sldMkLst>
          <pc:docMk/>
          <pc:sldMk cId="1088911210" sldId="272"/>
        </pc:sldMkLst>
      </pc:sldChg>
      <pc:sldChg chg="addSp delSp modSp add mod">
        <pc:chgData name="kenichiro otsuka" userId="99cd8c0872cf49df" providerId="LiveId" clId="{AF851DEA-67F2-BA47-8DF6-D3B416D6B570}" dt="2021-11-22T01:38:03.615" v="519" actId="14100"/>
        <pc:sldMkLst>
          <pc:docMk/>
          <pc:sldMk cId="3134786594" sldId="272"/>
        </pc:sldMkLst>
        <pc:spChg chg="mod">
          <ac:chgData name="kenichiro otsuka" userId="99cd8c0872cf49df" providerId="LiveId" clId="{AF851DEA-67F2-BA47-8DF6-D3B416D6B570}" dt="2021-11-22T01:38:03.615" v="519" actId="14100"/>
          <ac:spMkLst>
            <pc:docMk/>
            <pc:sldMk cId="3134786594" sldId="272"/>
            <ac:spMk id="5" creationId="{00000000-0000-0000-0000-000000000000}"/>
          </ac:spMkLst>
        </pc:spChg>
        <pc:picChg chg="add del mod">
          <ac:chgData name="kenichiro otsuka" userId="99cd8c0872cf49df" providerId="LiveId" clId="{AF851DEA-67F2-BA47-8DF6-D3B416D6B570}" dt="2021-11-22T01:33:00.154" v="490" actId="478"/>
          <ac:picMkLst>
            <pc:docMk/>
            <pc:sldMk cId="3134786594" sldId="272"/>
            <ac:picMk id="7" creationId="{BC1A6295-B63A-644D-8FA0-6895412E436E}"/>
          </ac:picMkLst>
        </pc:picChg>
        <pc:picChg chg="del">
          <ac:chgData name="kenichiro otsuka" userId="99cd8c0872cf49df" providerId="LiveId" clId="{AF851DEA-67F2-BA47-8DF6-D3B416D6B570}" dt="2021-11-22T01:29:57.360" v="455" actId="478"/>
          <ac:picMkLst>
            <pc:docMk/>
            <pc:sldMk cId="3134786594" sldId="272"/>
            <ac:picMk id="8" creationId="{B51E18CA-5660-D940-BE34-F8EAEFBD9919}"/>
          </ac:picMkLst>
        </pc:picChg>
        <pc:picChg chg="del">
          <ac:chgData name="kenichiro otsuka" userId="99cd8c0872cf49df" providerId="LiveId" clId="{AF851DEA-67F2-BA47-8DF6-D3B416D6B570}" dt="2021-11-22T01:29:58.083" v="456" actId="478"/>
          <ac:picMkLst>
            <pc:docMk/>
            <pc:sldMk cId="3134786594" sldId="272"/>
            <ac:picMk id="9" creationId="{5AB04E7A-7BDF-6941-B96B-5C8D6483986A}"/>
          </ac:picMkLst>
        </pc:picChg>
        <pc:picChg chg="add mod">
          <ac:chgData name="kenichiro otsuka" userId="99cd8c0872cf49df" providerId="LiveId" clId="{AF851DEA-67F2-BA47-8DF6-D3B416D6B570}" dt="2021-11-22T01:35:38.730" v="509" actId="1076"/>
          <ac:picMkLst>
            <pc:docMk/>
            <pc:sldMk cId="3134786594" sldId="272"/>
            <ac:picMk id="10" creationId="{CAC09AF5-CAA8-8342-837A-A91C15421D78}"/>
          </ac:picMkLst>
        </pc:picChg>
        <pc:picChg chg="add mod">
          <ac:chgData name="kenichiro otsuka" userId="99cd8c0872cf49df" providerId="LiveId" clId="{AF851DEA-67F2-BA47-8DF6-D3B416D6B570}" dt="2021-11-22T01:35:43.285" v="512" actId="1076"/>
          <ac:picMkLst>
            <pc:docMk/>
            <pc:sldMk cId="3134786594" sldId="272"/>
            <ac:picMk id="11" creationId="{F696DDF6-493E-6549-A01A-46B67A4FE511}"/>
          </ac:picMkLst>
        </pc:picChg>
        <pc:picChg chg="add del mod">
          <ac:chgData name="kenichiro otsuka" userId="99cd8c0872cf49df" providerId="LiveId" clId="{AF851DEA-67F2-BA47-8DF6-D3B416D6B570}" dt="2021-11-22T01:33:11.515" v="493" actId="478"/>
          <ac:picMkLst>
            <pc:docMk/>
            <pc:sldMk cId="3134786594" sldId="272"/>
            <ac:picMk id="13" creationId="{B0837F8B-0573-BF4F-8238-C7A3F103363F}"/>
          </ac:picMkLst>
        </pc:picChg>
        <pc:picChg chg="add mod">
          <ac:chgData name="kenichiro otsuka" userId="99cd8c0872cf49df" providerId="LiveId" clId="{AF851DEA-67F2-BA47-8DF6-D3B416D6B570}" dt="2021-11-22T01:35:45.226" v="513" actId="1076"/>
          <ac:picMkLst>
            <pc:docMk/>
            <pc:sldMk cId="3134786594" sldId="272"/>
            <ac:picMk id="15" creationId="{09E02468-C47C-B540-B876-E46C9999B014}"/>
          </ac:picMkLst>
        </pc:picChg>
      </pc:sldChg>
      <pc:sldChg chg="add del">
        <pc:chgData name="kenichiro otsuka" userId="99cd8c0872cf49df" providerId="LiveId" clId="{AF851DEA-67F2-BA47-8DF6-D3B416D6B570}" dt="2021-11-22T00:16:23.663" v="203" actId="2696"/>
        <pc:sldMkLst>
          <pc:docMk/>
          <pc:sldMk cId="2042616615" sldId="273"/>
        </pc:sldMkLst>
      </pc:sldChg>
    </pc:docChg>
  </pc:docChgLst>
  <pc:docChgLst>
    <pc:chgData name="kenichiro otsuka" userId="99cd8c0872cf49df" providerId="LiveId" clId="{2A186DDE-2B61-4F43-B2A9-81F7CFF936CA}"/>
    <pc:docChg chg="undo custSel modSld">
      <pc:chgData name="kenichiro otsuka" userId="99cd8c0872cf49df" providerId="LiveId" clId="{2A186DDE-2B61-4F43-B2A9-81F7CFF936CA}" dt="2021-09-22T07:39:13.337" v="171" actId="20577"/>
      <pc:docMkLst>
        <pc:docMk/>
      </pc:docMkLst>
      <pc:sldChg chg="delSp modSp mod">
        <pc:chgData name="kenichiro otsuka" userId="99cd8c0872cf49df" providerId="LiveId" clId="{2A186DDE-2B61-4F43-B2A9-81F7CFF936CA}" dt="2021-09-15T01:24:45.388" v="6" actId="20577"/>
        <pc:sldMkLst>
          <pc:docMk/>
          <pc:sldMk cId="2079782646" sldId="262"/>
        </pc:sldMkLst>
        <pc:spChg chg="mod">
          <ac:chgData name="kenichiro otsuka" userId="99cd8c0872cf49df" providerId="LiveId" clId="{2A186DDE-2B61-4F43-B2A9-81F7CFF936CA}" dt="2021-09-15T01:24:45.388" v="6" actId="20577"/>
          <ac:spMkLst>
            <pc:docMk/>
            <pc:sldMk cId="2079782646" sldId="262"/>
            <ac:spMk id="5" creationId="{00000000-0000-0000-0000-000000000000}"/>
          </ac:spMkLst>
        </pc:spChg>
        <pc:spChg chg="del">
          <ac:chgData name="kenichiro otsuka" userId="99cd8c0872cf49df" providerId="LiveId" clId="{2A186DDE-2B61-4F43-B2A9-81F7CFF936CA}" dt="2021-09-15T01:24:32.814" v="2" actId="478"/>
          <ac:spMkLst>
            <pc:docMk/>
            <pc:sldMk cId="2079782646" sldId="262"/>
            <ac:spMk id="6" creationId="{00000000-0000-0000-0000-000000000000}"/>
          </ac:spMkLst>
        </pc:spChg>
      </pc:sldChg>
      <pc:sldChg chg="modSp mod">
        <pc:chgData name="kenichiro otsuka" userId="99cd8c0872cf49df" providerId="LiveId" clId="{2A186DDE-2B61-4F43-B2A9-81F7CFF936CA}" dt="2021-09-15T01:25:27.254" v="10"/>
        <pc:sldMkLst>
          <pc:docMk/>
          <pc:sldMk cId="2883334632" sldId="263"/>
        </pc:sldMkLst>
        <pc:spChg chg="mod">
          <ac:chgData name="kenichiro otsuka" userId="99cd8c0872cf49df" providerId="LiveId" clId="{2A186DDE-2B61-4F43-B2A9-81F7CFF936CA}" dt="2021-09-15T01:25:27.254" v="10"/>
          <ac:spMkLst>
            <pc:docMk/>
            <pc:sldMk cId="2883334632" sldId="263"/>
            <ac:spMk id="5" creationId="{00000000-0000-0000-0000-000000000000}"/>
          </ac:spMkLst>
        </pc:spChg>
      </pc:sldChg>
      <pc:sldChg chg="modSp mod">
        <pc:chgData name="kenichiro otsuka" userId="99cd8c0872cf49df" providerId="LiveId" clId="{2A186DDE-2B61-4F43-B2A9-81F7CFF936CA}" dt="2021-09-15T01:26:50.701" v="17" actId="27636"/>
        <pc:sldMkLst>
          <pc:docMk/>
          <pc:sldMk cId="149728198" sldId="264"/>
        </pc:sldMkLst>
        <pc:spChg chg="mod">
          <ac:chgData name="kenichiro otsuka" userId="99cd8c0872cf49df" providerId="LiveId" clId="{2A186DDE-2B61-4F43-B2A9-81F7CFF936CA}" dt="2021-09-15T01:26:31.732" v="15"/>
          <ac:spMkLst>
            <pc:docMk/>
            <pc:sldMk cId="149728198" sldId="264"/>
            <ac:spMk id="5" creationId="{00000000-0000-0000-0000-000000000000}"/>
          </ac:spMkLst>
        </pc:spChg>
        <pc:spChg chg="mod">
          <ac:chgData name="kenichiro otsuka" userId="99cd8c0872cf49df" providerId="LiveId" clId="{2A186DDE-2B61-4F43-B2A9-81F7CFF936CA}" dt="2021-09-15T01:26:50.701" v="17" actId="27636"/>
          <ac:spMkLst>
            <pc:docMk/>
            <pc:sldMk cId="149728198" sldId="264"/>
            <ac:spMk id="6" creationId="{00000000-0000-0000-0000-000000000000}"/>
          </ac:spMkLst>
        </pc:spChg>
      </pc:sldChg>
      <pc:sldChg chg="modSp mod">
        <pc:chgData name="kenichiro otsuka" userId="99cd8c0872cf49df" providerId="LiveId" clId="{2A186DDE-2B61-4F43-B2A9-81F7CFF936CA}" dt="2021-09-15T01:26:04.637" v="14"/>
        <pc:sldMkLst>
          <pc:docMk/>
          <pc:sldMk cId="2946818097" sldId="265"/>
        </pc:sldMkLst>
        <pc:spChg chg="mod">
          <ac:chgData name="kenichiro otsuka" userId="99cd8c0872cf49df" providerId="LiveId" clId="{2A186DDE-2B61-4F43-B2A9-81F7CFF936CA}" dt="2021-09-15T01:26:04.637" v="14"/>
          <ac:spMkLst>
            <pc:docMk/>
            <pc:sldMk cId="2946818097" sldId="265"/>
            <ac:spMk id="5" creationId="{00000000-0000-0000-0000-000000000000}"/>
          </ac:spMkLst>
        </pc:spChg>
      </pc:sldChg>
      <pc:sldChg chg="modSp mod">
        <pc:chgData name="kenichiro otsuka" userId="99cd8c0872cf49df" providerId="LiveId" clId="{2A186DDE-2B61-4F43-B2A9-81F7CFF936CA}" dt="2021-09-22T07:35:12.137" v="40" actId="404"/>
        <pc:sldMkLst>
          <pc:docMk/>
          <pc:sldMk cId="349600417" sldId="266"/>
        </pc:sldMkLst>
        <pc:spChg chg="mod">
          <ac:chgData name="kenichiro otsuka" userId="99cd8c0872cf49df" providerId="LiveId" clId="{2A186DDE-2B61-4F43-B2A9-81F7CFF936CA}" dt="2021-09-22T07:35:06.354" v="39" actId="1076"/>
          <ac:spMkLst>
            <pc:docMk/>
            <pc:sldMk cId="349600417" sldId="266"/>
            <ac:spMk id="3" creationId="{00000000-0000-0000-0000-000000000000}"/>
          </ac:spMkLst>
        </pc:spChg>
        <pc:spChg chg="mod">
          <ac:chgData name="kenichiro otsuka" userId="99cd8c0872cf49df" providerId="LiveId" clId="{2A186DDE-2B61-4F43-B2A9-81F7CFF936CA}" dt="2021-09-22T07:34:24.266" v="27" actId="27636"/>
          <ac:spMkLst>
            <pc:docMk/>
            <pc:sldMk cId="349600417" sldId="266"/>
            <ac:spMk id="5" creationId="{00000000-0000-0000-0000-000000000000}"/>
          </ac:spMkLst>
        </pc:spChg>
        <pc:spChg chg="mod">
          <ac:chgData name="kenichiro otsuka" userId="99cd8c0872cf49df" providerId="LiveId" clId="{2A186DDE-2B61-4F43-B2A9-81F7CFF936CA}" dt="2021-09-22T07:35:12.137" v="40" actId="404"/>
          <ac:spMkLst>
            <pc:docMk/>
            <pc:sldMk cId="349600417" sldId="266"/>
            <ac:spMk id="6" creationId="{00000000-0000-0000-0000-000000000000}"/>
          </ac:spMkLst>
        </pc:spChg>
      </pc:sldChg>
      <pc:sldChg chg="modSp">
        <pc:chgData name="kenichiro otsuka" userId="99cd8c0872cf49df" providerId="LiveId" clId="{2A186DDE-2B61-4F43-B2A9-81F7CFF936CA}" dt="2021-09-22T07:35:52.150" v="41"/>
        <pc:sldMkLst>
          <pc:docMk/>
          <pc:sldMk cId="1514158967" sldId="267"/>
        </pc:sldMkLst>
        <pc:spChg chg="mod">
          <ac:chgData name="kenichiro otsuka" userId="99cd8c0872cf49df" providerId="LiveId" clId="{2A186DDE-2B61-4F43-B2A9-81F7CFF936CA}" dt="2021-09-22T07:35:52.150" v="41"/>
          <ac:spMkLst>
            <pc:docMk/>
            <pc:sldMk cId="1514158967" sldId="267"/>
            <ac:spMk id="5" creationId="{00000000-0000-0000-0000-000000000000}"/>
          </ac:spMkLst>
        </pc:spChg>
      </pc:sldChg>
      <pc:sldChg chg="addSp delSp modSp mod">
        <pc:chgData name="kenichiro otsuka" userId="99cd8c0872cf49df" providerId="LiveId" clId="{2A186DDE-2B61-4F43-B2A9-81F7CFF936CA}" dt="2021-09-22T07:39:13.337" v="171" actId="20577"/>
        <pc:sldMkLst>
          <pc:docMk/>
          <pc:sldMk cId="1470050889" sldId="269"/>
        </pc:sldMkLst>
        <pc:spChg chg="mod">
          <ac:chgData name="kenichiro otsuka" userId="99cd8c0872cf49df" providerId="LiveId" clId="{2A186DDE-2B61-4F43-B2A9-81F7CFF936CA}" dt="2021-09-22T07:38:30.465" v="93" actId="20577"/>
          <ac:spMkLst>
            <pc:docMk/>
            <pc:sldMk cId="1470050889" sldId="269"/>
            <ac:spMk id="5" creationId="{00000000-0000-0000-0000-000000000000}"/>
          </ac:spMkLst>
        </pc:spChg>
        <pc:spChg chg="mod">
          <ac:chgData name="kenichiro otsuka" userId="99cd8c0872cf49df" providerId="LiveId" clId="{2A186DDE-2B61-4F43-B2A9-81F7CFF936CA}" dt="2021-09-22T07:39:13.337" v="171" actId="20577"/>
          <ac:spMkLst>
            <pc:docMk/>
            <pc:sldMk cId="1470050889" sldId="269"/>
            <ac:spMk id="6" creationId="{00000000-0000-0000-0000-000000000000}"/>
          </ac:spMkLst>
        </pc:spChg>
        <pc:spChg chg="mod">
          <ac:chgData name="kenichiro otsuka" userId="99cd8c0872cf49df" providerId="LiveId" clId="{2A186DDE-2B61-4F43-B2A9-81F7CFF936CA}" dt="2021-09-22T07:38:41.524" v="117" actId="20577"/>
          <ac:spMkLst>
            <pc:docMk/>
            <pc:sldMk cId="1470050889" sldId="269"/>
            <ac:spMk id="7" creationId="{00000000-0000-0000-0000-000000000000}"/>
          </ac:spMkLst>
        </pc:spChg>
        <pc:spChg chg="add del">
          <ac:chgData name="kenichiro otsuka" userId="99cd8c0872cf49df" providerId="LiveId" clId="{2A186DDE-2B61-4F43-B2A9-81F7CFF936CA}" dt="2021-09-22T07:38:00.957" v="47"/>
          <ac:spMkLst>
            <pc:docMk/>
            <pc:sldMk cId="1470050889" sldId="269"/>
            <ac:spMk id="8" creationId="{00000000-0000-0000-0000-000000000000}"/>
          </ac:spMkLst>
        </pc:spChg>
        <pc:spChg chg="del">
          <ac:chgData name="kenichiro otsuka" userId="99cd8c0872cf49df" providerId="LiveId" clId="{2A186DDE-2B61-4F43-B2A9-81F7CFF936CA}" dt="2021-09-22T07:37:32.780" v="46"/>
          <ac:spMkLst>
            <pc:docMk/>
            <pc:sldMk cId="1470050889" sldId="269"/>
            <ac:spMk id="10" creationId="{00000000-0000-0000-0000-000000000000}"/>
          </ac:spMkLst>
        </pc:spChg>
        <pc:picChg chg="add del mod">
          <ac:chgData name="kenichiro otsuka" userId="99cd8c0872cf49df" providerId="LiveId" clId="{2A186DDE-2B61-4F43-B2A9-81F7CFF936CA}" dt="2021-09-22T07:37:13.852" v="45"/>
          <ac:picMkLst>
            <pc:docMk/>
            <pc:sldMk cId="1470050889" sldId="269"/>
            <ac:picMk id="11" creationId="{9CF6EF18-F887-BF47-A9FC-E3BD5C3CB63A}"/>
          </ac:picMkLst>
        </pc:picChg>
        <pc:picChg chg="add mod">
          <ac:chgData name="kenichiro otsuka" userId="99cd8c0872cf49df" providerId="LiveId" clId="{2A186DDE-2B61-4F43-B2A9-81F7CFF936CA}" dt="2021-09-22T07:37:32.780" v="46"/>
          <ac:picMkLst>
            <pc:docMk/>
            <pc:sldMk cId="1470050889" sldId="269"/>
            <ac:picMk id="12" creationId="{36F32474-D26D-7A40-B449-910EA74064CF}"/>
          </ac:picMkLst>
        </pc:picChg>
        <pc:picChg chg="add mod">
          <ac:chgData name="kenichiro otsuka" userId="99cd8c0872cf49df" providerId="LiveId" clId="{2A186DDE-2B61-4F43-B2A9-81F7CFF936CA}" dt="2021-09-22T07:38:08.874" v="48" actId="1076"/>
          <ac:picMkLst>
            <pc:docMk/>
            <pc:sldMk cId="1470050889" sldId="269"/>
            <ac:picMk id="13" creationId="{18C4E04B-F007-CE46-A96A-406B9CA7B4DC}"/>
          </ac:picMkLst>
        </pc:picChg>
      </pc:sldChg>
      <pc:sldChg chg="modSp mod">
        <pc:chgData name="kenichiro otsuka" userId="99cd8c0872cf49df" providerId="LiveId" clId="{2A186DDE-2B61-4F43-B2A9-81F7CFF936CA}" dt="2021-09-22T07:33:16.958" v="23"/>
        <pc:sldMkLst>
          <pc:docMk/>
          <pc:sldMk cId="2298962906" sldId="270"/>
        </pc:sldMkLst>
        <pc:spChg chg="mod">
          <ac:chgData name="kenichiro otsuka" userId="99cd8c0872cf49df" providerId="LiveId" clId="{2A186DDE-2B61-4F43-B2A9-81F7CFF936CA}" dt="2021-09-22T07:33:16.958" v="23"/>
          <ac:spMkLst>
            <pc:docMk/>
            <pc:sldMk cId="2298962906" sldId="270"/>
            <ac:spMk id="5" creationId="{00000000-0000-0000-0000-000000000000}"/>
          </ac:spMkLst>
        </pc:sp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11/07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11/07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ti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4748" y="3438651"/>
            <a:ext cx="6120680" cy="713082"/>
          </a:xfrm>
        </p:spPr>
        <p:txBody>
          <a:bodyPr>
            <a:noAutofit/>
          </a:bodyPr>
          <a:lstStyle/>
          <a:p>
            <a:r>
              <a:rPr lang="en-GB" altLang="ja-JP" sz="1400" dirty="0"/>
              <a:t>Evaluations of Coronary Microvascular Dysfunction in a Patient with Thrombotic Microangiopathy and Cardiac Troponin Elevation: A Case Report</a:t>
            </a:r>
            <a:br>
              <a:rPr lang="ja-JP" altLang="ja-JP" sz="1400"/>
            </a:br>
            <a:endParaRPr lang="en-GB" sz="140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May 2022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57B4312-A014-B947-AE9E-90F90909AF08}"/>
              </a:ext>
            </a:extLst>
          </p:cNvPr>
          <p:cNvSpPr txBox="1"/>
          <p:nvPr/>
        </p:nvSpPr>
        <p:spPr>
          <a:xfrm>
            <a:off x="-146957" y="4269921"/>
            <a:ext cx="0" cy="0"/>
          </a:xfrm>
          <a:prstGeom prst="rect">
            <a:avLst/>
          </a:prstGeom>
        </p:spPr>
        <p:txBody>
          <a:bodyPr vert="horz" wrap="none" lIns="0" tIns="0" rIns="0" bIns="0" rtlCol="0" anchor="t">
            <a:normAutofit fontScale="25000" lnSpcReduction="20000"/>
          </a:bodyPr>
          <a:lstStyle/>
          <a:p>
            <a:endParaRPr kumimoji="1" lang="ja-JP" altLang="en-US" dirty="0"/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9E1797CC-2CB6-F61C-FE68-61AB5894E23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1115616" y="4515966"/>
            <a:ext cx="6119812" cy="287338"/>
          </a:xfrm>
        </p:spPr>
        <p:txBody>
          <a:bodyPr>
            <a:normAutofit fontScale="85000" lnSpcReduction="20000"/>
          </a:bodyPr>
          <a:lstStyle/>
          <a:p>
            <a:r>
              <a:rPr lang="en-US" altLang="ja-JP" sz="1800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Learning Point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643370" y="1636894"/>
            <a:ext cx="2624456" cy="3116394"/>
          </a:xfrm>
        </p:spPr>
        <p:txBody>
          <a:bodyPr>
            <a:normAutofit/>
          </a:bodyPr>
          <a:lstStyle/>
          <a:p>
            <a:pPr marL="285750" lvl="0" indent="-285750">
              <a:buFont typeface="Wingdings" pitchFamily="2" charset="2"/>
              <a:buChar char="ü"/>
            </a:pPr>
            <a:r>
              <a:rPr lang="en-US" altLang="ja-JP" dirty="0"/>
              <a:t>TMA can be life-threatening, and its underlying mechanisms involve platelet aggregation and increased mechanical stress in the microcirculation.</a:t>
            </a:r>
            <a:endParaRPr lang="ja-JP" altLang="ja-JP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69264" y="1636894"/>
            <a:ext cx="2205471" cy="2620968"/>
          </a:xfrm>
        </p:spPr>
        <p:txBody>
          <a:bodyPr>
            <a:noAutofit/>
          </a:bodyPr>
          <a:lstStyle/>
          <a:p>
            <a:pPr marL="285750" lvl="0" indent="-285750">
              <a:buFont typeface="Wingdings" pitchFamily="2" charset="2"/>
              <a:buChar char="ü"/>
            </a:pPr>
            <a:r>
              <a:rPr lang="en-US" altLang="ja-JP" dirty="0"/>
              <a:t>CMD caused by TMA contributes to multiple organ failure, myocardial infarction/injury, and sudden cardiac death.</a:t>
            </a:r>
            <a:endParaRPr lang="ja-JP" altLang="ja-JP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833477" y="1636894"/>
            <a:ext cx="2624456" cy="2917085"/>
          </a:xfrm>
        </p:spPr>
        <p:txBody>
          <a:bodyPr>
            <a:noAutofit/>
          </a:bodyPr>
          <a:lstStyle/>
          <a:p>
            <a:pPr marL="285750" lvl="0" indent="-285750">
              <a:buFont typeface="Wingdings" pitchFamily="2" charset="2"/>
              <a:buChar char="ü"/>
            </a:pPr>
            <a:r>
              <a:rPr lang="en-US" altLang="ja-JP" dirty="0"/>
              <a:t>Non-invasive assessment of coronary microvascular function and its recovery can provide mechanistic insights into the cardiac involvement in TMA.</a:t>
            </a:r>
            <a:endParaRPr lang="ja-JP" altLang="ja-JP"/>
          </a:p>
          <a:p>
            <a:endParaRPr lang="en-GB" sz="1800" dirty="0"/>
          </a:p>
        </p:txBody>
      </p:sp>
      <p:pic>
        <p:nvPicPr>
          <p:cNvPr id="8" name="Picture 6" descr="Graphical user interface, website&#10;&#10;Description automatically generated">
            <a:extLst>
              <a:ext uri="{FF2B5EF4-FFF2-40B4-BE49-F238E27FC236}">
                <a16:creationId xmlns:a16="http://schemas.microsoft.com/office/drawing/2014/main" id="{B4DA225A-F7D0-B6BF-62D1-DCF534B811A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5" t="10985" b="44879"/>
          <a:stretch/>
        </p:blipFill>
        <p:spPr>
          <a:xfrm>
            <a:off x="1057758" y="660355"/>
            <a:ext cx="3292536" cy="857250"/>
          </a:xfrm>
          <a:prstGeom prst="rect">
            <a:avLst/>
          </a:prstGeom>
        </p:spPr>
      </p:pic>
      <p:pic>
        <p:nvPicPr>
          <p:cNvPr id="9" name="Picture 6" descr="Graphical user interface, website&#10;&#10;Description automatically generated">
            <a:extLst>
              <a:ext uri="{FF2B5EF4-FFF2-40B4-BE49-F238E27FC236}">
                <a16:creationId xmlns:a16="http://schemas.microsoft.com/office/drawing/2014/main" id="{6D1F061A-EEE0-FE69-2EAE-D2254EC759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8" t="54891" r="1187" b="973"/>
          <a:stretch/>
        </p:blipFill>
        <p:spPr>
          <a:xfrm>
            <a:off x="4793707" y="649193"/>
            <a:ext cx="3292536" cy="857250"/>
          </a:xfrm>
          <a:prstGeom prst="rect">
            <a:avLst/>
          </a:prstGeom>
        </p:spPr>
      </p:pic>
      <p:sp>
        <p:nvSpPr>
          <p:cNvPr id="3" name="右矢印 2">
            <a:extLst>
              <a:ext uri="{FF2B5EF4-FFF2-40B4-BE49-F238E27FC236}">
                <a16:creationId xmlns:a16="http://schemas.microsoft.com/office/drawing/2014/main" id="{638D4571-03F1-6989-6FCB-952297B57DAA}"/>
              </a:ext>
            </a:extLst>
          </p:cNvPr>
          <p:cNvSpPr/>
          <p:nvPr/>
        </p:nvSpPr>
        <p:spPr>
          <a:xfrm>
            <a:off x="4396972" y="885638"/>
            <a:ext cx="350056" cy="48463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42D78F74-5FEF-5A81-6701-DF13CC056377}"/>
              </a:ext>
            </a:extLst>
          </p:cNvPr>
          <p:cNvSpPr txBox="1">
            <a:spLocks/>
          </p:cNvSpPr>
          <p:nvPr/>
        </p:nvSpPr>
        <p:spPr>
          <a:xfrm>
            <a:off x="1238080" y="4711908"/>
            <a:ext cx="6119812" cy="287338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kern="0">
                <a:solidFill>
                  <a:schemeClr val="accent1">
                    <a:lumMod val="60000"/>
                    <a:lumOff val="40000"/>
                  </a:schemeClr>
                </a:solidFill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コンテンツ プレースホルダー 4">
            <a:extLst>
              <a:ext uri="{FF2B5EF4-FFF2-40B4-BE49-F238E27FC236}">
                <a16:creationId xmlns:a16="http://schemas.microsoft.com/office/drawing/2014/main" id="{612B559E-E3A9-D381-F045-F23290DAB39D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873578" y="889906"/>
            <a:ext cx="3167743" cy="3559243"/>
          </a:xfrm>
        </p:spPr>
        <p:txBody>
          <a:bodyPr>
            <a:normAutofit lnSpcReduction="10000"/>
          </a:bodyPr>
          <a:lstStyle/>
          <a:p>
            <a:pPr marL="138113" indent="-138113"/>
            <a:r>
              <a:rPr lang="en-US" altLang="ja-JP" sz="900" dirty="0"/>
              <a:t>1. George JN, Nester CM. Syndromes of thrombotic microangiopathy. </a:t>
            </a:r>
            <a:r>
              <a:rPr lang="en-US" altLang="ja-JP" sz="900" i="1" dirty="0"/>
              <a:t>N </a:t>
            </a:r>
            <a:r>
              <a:rPr lang="en-US" altLang="ja-JP" sz="900" i="1" dirty="0" err="1"/>
              <a:t>Engl</a:t>
            </a:r>
            <a:r>
              <a:rPr lang="en-US" altLang="ja-JP" sz="900" i="1" dirty="0"/>
              <a:t> J Med</a:t>
            </a:r>
            <a:r>
              <a:rPr lang="en-US" altLang="ja-JP" sz="900" dirty="0"/>
              <a:t> 2014;371:654–666. </a:t>
            </a:r>
            <a:endParaRPr lang="ja-JP" altLang="ja-JP" sz="900"/>
          </a:p>
          <a:p>
            <a:pPr marL="138113" indent="-138113"/>
            <a:r>
              <a:rPr lang="en-US" altLang="ja-JP" sz="900" dirty="0"/>
              <a:t>2. </a:t>
            </a:r>
            <a:r>
              <a:rPr lang="en-US" altLang="ja-JP" sz="900" dirty="0" err="1"/>
              <a:t>Wahla</a:t>
            </a:r>
            <a:r>
              <a:rPr lang="en-US" altLang="ja-JP" sz="900" dirty="0"/>
              <a:t> AS, Ruiz J, Noureddine N, </a:t>
            </a:r>
            <a:r>
              <a:rPr lang="en-US" altLang="ja-JP" sz="900" dirty="0" err="1"/>
              <a:t>Upadhya</a:t>
            </a:r>
            <a:r>
              <a:rPr lang="en-US" altLang="ja-JP" sz="900" dirty="0"/>
              <a:t> B, </a:t>
            </a:r>
            <a:r>
              <a:rPr lang="en-US" altLang="ja-JP" sz="900" dirty="0" err="1"/>
              <a:t>Scane</a:t>
            </a:r>
            <a:r>
              <a:rPr lang="en-US" altLang="ja-JP" sz="900" dirty="0"/>
              <a:t> DC, Owen J. Myocardial infarction in thrombotic thrombocytopenic purpura: a single-center experience and literature review. </a:t>
            </a:r>
            <a:r>
              <a:rPr lang="en-US" altLang="ja-JP" sz="900" i="1" dirty="0" err="1"/>
              <a:t>Eur</a:t>
            </a:r>
            <a:r>
              <a:rPr lang="en-US" altLang="ja-JP" sz="900" i="1" dirty="0"/>
              <a:t> J </a:t>
            </a:r>
            <a:r>
              <a:rPr lang="en-US" altLang="ja-JP" sz="900" i="1" dirty="0" err="1"/>
              <a:t>Haematol</a:t>
            </a:r>
            <a:r>
              <a:rPr lang="en-US" altLang="ja-JP" sz="900" dirty="0"/>
              <a:t> 2008;81:311–316. </a:t>
            </a:r>
            <a:endParaRPr lang="ja-JP" altLang="ja-JP" sz="900"/>
          </a:p>
          <a:p>
            <a:pPr marL="138113" indent="-138113"/>
            <a:r>
              <a:rPr lang="en-US" altLang="ja-JP" sz="900" dirty="0"/>
              <a:t>3. </a:t>
            </a:r>
            <a:r>
              <a:rPr lang="en-US" altLang="ja-JP" sz="900" dirty="0" err="1"/>
              <a:t>Knuuti</a:t>
            </a:r>
            <a:r>
              <a:rPr lang="en-US" altLang="ja-JP" sz="900" dirty="0"/>
              <a:t> J, </a:t>
            </a:r>
            <a:r>
              <a:rPr lang="en-US" altLang="ja-JP" sz="900" dirty="0" err="1"/>
              <a:t>Wijns</a:t>
            </a:r>
            <a:r>
              <a:rPr lang="en-US" altLang="ja-JP" sz="900" dirty="0"/>
              <a:t> W, </a:t>
            </a:r>
            <a:r>
              <a:rPr lang="en-US" altLang="ja-JP" sz="900" dirty="0" err="1"/>
              <a:t>Saraste</a:t>
            </a:r>
            <a:r>
              <a:rPr lang="en-US" altLang="ja-JP" sz="900" dirty="0"/>
              <a:t> A, Capodanno D, </a:t>
            </a:r>
            <a:r>
              <a:rPr lang="en-US" altLang="ja-JP" sz="900" dirty="0" err="1"/>
              <a:t>Barbato</a:t>
            </a:r>
            <a:r>
              <a:rPr lang="en-US" altLang="ja-JP" sz="900" dirty="0"/>
              <a:t> E, </a:t>
            </a:r>
            <a:r>
              <a:rPr lang="en-US" altLang="ja-JP" sz="900" dirty="0" err="1"/>
              <a:t>Funck</a:t>
            </a:r>
            <a:r>
              <a:rPr lang="en-US" altLang="ja-JP" sz="900" dirty="0"/>
              <a:t>-Brentano C, et al. 2019 ESC Guidelines for the diagnosis and management of chronic coronary syndromes. </a:t>
            </a:r>
            <a:r>
              <a:rPr lang="en-US" altLang="ja-JP" sz="900" i="1" dirty="0" err="1"/>
              <a:t>Eur</a:t>
            </a:r>
            <a:r>
              <a:rPr lang="en-US" altLang="ja-JP" sz="900" i="1" dirty="0"/>
              <a:t> Heart J</a:t>
            </a:r>
            <a:r>
              <a:rPr lang="en-US" altLang="ja-JP" sz="900" dirty="0"/>
              <a:t> 2020;41:407–477. </a:t>
            </a:r>
            <a:endParaRPr lang="ja-JP" altLang="ja-JP" sz="900"/>
          </a:p>
          <a:p>
            <a:pPr marL="138113" indent="-138113"/>
            <a:r>
              <a:rPr lang="en-US" altLang="ja-JP" sz="900" dirty="0"/>
              <a:t>4. </a:t>
            </a:r>
            <a:r>
              <a:rPr lang="en-US" altLang="ja-JP" sz="900" dirty="0" err="1"/>
              <a:t>Camici</a:t>
            </a:r>
            <a:r>
              <a:rPr lang="en-US" altLang="ja-JP" sz="900" dirty="0"/>
              <a:t> PG, </a:t>
            </a:r>
            <a:r>
              <a:rPr lang="en-US" altLang="ja-JP" sz="900" dirty="0" err="1"/>
              <a:t>d’Amati</a:t>
            </a:r>
            <a:r>
              <a:rPr lang="en-US" altLang="ja-JP" sz="900" dirty="0"/>
              <a:t> G, </a:t>
            </a:r>
            <a:r>
              <a:rPr lang="en-US" altLang="ja-JP" sz="900" dirty="0" err="1"/>
              <a:t>Rimoldi</a:t>
            </a:r>
            <a:r>
              <a:rPr lang="en-US" altLang="ja-JP" sz="900" dirty="0"/>
              <a:t> O. Coronary microvascular dysfunction: mechanisms and functional assessment. </a:t>
            </a:r>
            <a:r>
              <a:rPr lang="en-US" altLang="ja-JP" sz="900" i="1" dirty="0"/>
              <a:t>Nat Rev </a:t>
            </a:r>
            <a:r>
              <a:rPr lang="en-US" altLang="ja-JP" sz="900" i="1" dirty="0" err="1"/>
              <a:t>Cardiol</a:t>
            </a:r>
            <a:r>
              <a:rPr lang="en-US" altLang="ja-JP" sz="900" dirty="0"/>
              <a:t> 2015;12:48–62. </a:t>
            </a:r>
            <a:endParaRPr lang="ja-JP" altLang="ja-JP" sz="900"/>
          </a:p>
          <a:p>
            <a:pPr marL="138113" indent="-138113"/>
            <a:r>
              <a:rPr lang="en-US" altLang="ja-JP" sz="900" dirty="0"/>
              <a:t>5. Scully M, Hunt BJ, Benjamin S, </a:t>
            </a:r>
            <a:r>
              <a:rPr lang="en-US" altLang="ja-JP" sz="900" dirty="0" err="1"/>
              <a:t>Liesner</a:t>
            </a:r>
            <a:r>
              <a:rPr lang="en-US" altLang="ja-JP" sz="900" dirty="0"/>
              <a:t> R, Rose P, </a:t>
            </a:r>
            <a:r>
              <a:rPr lang="en-US" altLang="ja-JP" sz="900" dirty="0" err="1"/>
              <a:t>Peyvandi</a:t>
            </a:r>
            <a:r>
              <a:rPr lang="en-US" altLang="ja-JP" sz="900" dirty="0"/>
              <a:t> F, et al. Guidelines on the diagnosis and management of thrombotic thrombocytopenic purpura and other thrombotic microangiopathies. </a:t>
            </a:r>
            <a:r>
              <a:rPr lang="en-US" altLang="ja-JP" sz="900" i="1" dirty="0"/>
              <a:t>Br J </a:t>
            </a:r>
            <a:r>
              <a:rPr lang="en-US" altLang="ja-JP" sz="900" i="1" dirty="0" err="1"/>
              <a:t>Haematol</a:t>
            </a:r>
            <a:r>
              <a:rPr lang="en-US" altLang="ja-JP" sz="900" dirty="0"/>
              <a:t> 2012;158:323–335. </a:t>
            </a:r>
            <a:endParaRPr lang="ja-JP" altLang="ja-JP" sz="900"/>
          </a:p>
          <a:p>
            <a:pPr marL="138113" indent="-138113"/>
            <a:r>
              <a:rPr lang="en-US" altLang="ja-JP" sz="900" dirty="0"/>
              <a:t>6. Samuel A, Garris R, Upadhyay S, </a:t>
            </a:r>
            <a:r>
              <a:rPr lang="en-US" altLang="ja-JP" sz="900" dirty="0" err="1"/>
              <a:t>Ghrewati</a:t>
            </a:r>
            <a:r>
              <a:rPr lang="en-US" altLang="ja-JP" sz="900" dirty="0"/>
              <a:t> M, </a:t>
            </a:r>
            <a:r>
              <a:rPr lang="en-US" altLang="ja-JP" sz="900" dirty="0" err="1"/>
              <a:t>Guragai</a:t>
            </a:r>
            <a:r>
              <a:rPr lang="en-US" altLang="ja-JP" sz="900" dirty="0"/>
              <a:t> N. An Atypical Presentation of Thrombotic Thrombocytopenic Purpura With Concurrent Acute Coronary Syndrome and Cerebrovascular Accident. </a:t>
            </a:r>
            <a:r>
              <a:rPr lang="en-US" altLang="ja-JP" sz="900" i="1" dirty="0"/>
              <a:t>Chest</a:t>
            </a:r>
            <a:r>
              <a:rPr lang="en-US" altLang="ja-JP" sz="900" dirty="0"/>
              <a:t> 2019;156:A1262.</a:t>
            </a:r>
          </a:p>
          <a:p>
            <a:pPr marL="138113" indent="-138113"/>
            <a:r>
              <a:rPr lang="en-US" altLang="ja-JP" sz="900" dirty="0"/>
              <a:t>7.  Hawkins BM, Abu-Fadel M, Vesely SK, George JN. Clinical cardiac involvement in thrombotic thrombocytopenic purpura: a systematic review. </a:t>
            </a:r>
            <a:r>
              <a:rPr lang="en-US" altLang="ja-JP" sz="900" i="1" dirty="0"/>
              <a:t>Transfusion</a:t>
            </a:r>
            <a:r>
              <a:rPr lang="en-US" altLang="ja-JP" sz="900" dirty="0"/>
              <a:t> 2008;48:382–392. </a:t>
            </a:r>
            <a:endParaRPr lang="ja-JP" altLang="ja-JP" sz="900"/>
          </a:p>
          <a:p>
            <a:endParaRPr lang="ja-JP" altLang="ja-JP" sz="900"/>
          </a:p>
          <a:p>
            <a:endParaRPr lang="ja-JP" altLang="en-US" sz="1000"/>
          </a:p>
        </p:txBody>
      </p:sp>
      <p:sp>
        <p:nvSpPr>
          <p:cNvPr id="6" name="コンテンツ プレースホルダー 4">
            <a:extLst>
              <a:ext uri="{FF2B5EF4-FFF2-40B4-BE49-F238E27FC236}">
                <a16:creationId xmlns:a16="http://schemas.microsoft.com/office/drawing/2014/main" id="{B15753D3-35C8-C16C-3F33-1E32856D3D2A}"/>
              </a:ext>
            </a:extLst>
          </p:cNvPr>
          <p:cNvSpPr txBox="1">
            <a:spLocks/>
          </p:cNvSpPr>
          <p:nvPr/>
        </p:nvSpPr>
        <p:spPr>
          <a:xfrm>
            <a:off x="4247964" y="889906"/>
            <a:ext cx="4180114" cy="461055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138113" indent="-138113"/>
            <a:r>
              <a:rPr lang="en-US" altLang="ja-JP" sz="900" dirty="0"/>
              <a:t>8.  Benhamou Y, </a:t>
            </a:r>
            <a:r>
              <a:rPr lang="en-US" altLang="ja-JP" sz="900" dirty="0" err="1"/>
              <a:t>Boelle</a:t>
            </a:r>
            <a:r>
              <a:rPr lang="en-US" altLang="ja-JP" sz="900" dirty="0"/>
              <a:t> P-Y, </a:t>
            </a:r>
            <a:r>
              <a:rPr lang="en-US" altLang="ja-JP" sz="900" dirty="0" err="1"/>
              <a:t>Baudin</a:t>
            </a:r>
            <a:r>
              <a:rPr lang="en-US" altLang="ja-JP" sz="900" dirty="0"/>
              <a:t> B, </a:t>
            </a:r>
            <a:r>
              <a:rPr lang="en-US" altLang="ja-JP" sz="900" dirty="0" err="1"/>
              <a:t>Ederhy</a:t>
            </a:r>
            <a:r>
              <a:rPr lang="en-US" altLang="ja-JP" sz="900" dirty="0"/>
              <a:t> S, Gras J, </a:t>
            </a:r>
            <a:r>
              <a:rPr lang="en-US" altLang="ja-JP" sz="900" dirty="0" err="1"/>
              <a:t>Galicier</a:t>
            </a:r>
            <a:r>
              <a:rPr lang="en-US" altLang="ja-JP" sz="900" dirty="0"/>
              <a:t> L, et al. Cardiac troponin-I on diagnosis predicts early death and refractoriness in acquired thrombotic thrombocytopenic purpura. Experience of the French Thrombotic Microangiopathies Reference Center. </a:t>
            </a:r>
            <a:r>
              <a:rPr lang="en-US" altLang="ja-JP" sz="900" i="1" dirty="0"/>
              <a:t>J </a:t>
            </a:r>
            <a:r>
              <a:rPr lang="en-US" altLang="ja-JP" sz="900" i="1" dirty="0" err="1"/>
              <a:t>Thromb</a:t>
            </a:r>
            <a:r>
              <a:rPr lang="en-US" altLang="ja-JP" sz="900" i="1" dirty="0"/>
              <a:t> </a:t>
            </a:r>
            <a:r>
              <a:rPr lang="en-US" altLang="ja-JP" sz="900" i="1" dirty="0" err="1"/>
              <a:t>Haemost</a:t>
            </a:r>
            <a:r>
              <a:rPr lang="en-US" altLang="ja-JP" sz="900" dirty="0"/>
              <a:t> 2015;13:293–302. </a:t>
            </a:r>
            <a:endParaRPr lang="ja-JP" altLang="ja-JP" sz="900"/>
          </a:p>
          <a:p>
            <a:pPr marL="138113" indent="-138113"/>
            <a:r>
              <a:rPr lang="en-US" altLang="ja-JP" sz="900" dirty="0"/>
              <a:t>9. Kubo T, Fukuda S, Hirata K, Shimada K, Maeda K, </a:t>
            </a:r>
            <a:r>
              <a:rPr lang="en-US" altLang="ja-JP" sz="900" dirty="0" err="1"/>
              <a:t>Komukai</a:t>
            </a:r>
            <a:r>
              <a:rPr lang="en-US" altLang="ja-JP" sz="900" dirty="0"/>
              <a:t> K, et al. Comparison of coronary microcirculation in female nurses after day-time versus night-time shifts. </a:t>
            </a:r>
            <a:r>
              <a:rPr lang="en-US" altLang="ja-JP" sz="900" i="1" dirty="0"/>
              <a:t>Am J </a:t>
            </a:r>
            <a:r>
              <a:rPr lang="en-US" altLang="ja-JP" sz="900" i="1" dirty="0" err="1"/>
              <a:t>Cardiol</a:t>
            </a:r>
            <a:r>
              <a:rPr lang="en-US" altLang="ja-JP" sz="900" dirty="0"/>
              <a:t> 2011;108:1665–1668. </a:t>
            </a:r>
            <a:endParaRPr lang="ja-JP" altLang="ja-JP" sz="900"/>
          </a:p>
          <a:p>
            <a:pPr marL="138113" indent="-138113"/>
            <a:r>
              <a:rPr lang="en-US" altLang="ja-JP" sz="900" dirty="0"/>
              <a:t>10. Otsuka K, Nakanishi K, Shimada K, Nakamura H, </a:t>
            </a:r>
            <a:r>
              <a:rPr lang="en-US" altLang="ja-JP" sz="900" dirty="0" err="1"/>
              <a:t>Inanami</a:t>
            </a:r>
            <a:r>
              <a:rPr lang="en-US" altLang="ja-JP" sz="900" dirty="0"/>
              <a:t> H, </a:t>
            </a:r>
            <a:r>
              <a:rPr lang="en-US" altLang="ja-JP" sz="900" dirty="0" err="1"/>
              <a:t>Nishioka</a:t>
            </a:r>
            <a:r>
              <a:rPr lang="en-US" altLang="ja-JP" sz="900" dirty="0"/>
              <a:t> H, et al. Associations of sensitive cardiac troponin-I with left ventricular morphology, function and prognosis in end-stage renal disease patients with preserved ejection fraction. </a:t>
            </a:r>
            <a:r>
              <a:rPr lang="en-US" altLang="ja-JP" sz="900" i="1" dirty="0"/>
              <a:t>Heart Vessels</a:t>
            </a:r>
            <a:r>
              <a:rPr lang="en-US" altLang="ja-JP" sz="900" dirty="0"/>
              <a:t> 2018;33:1334–1342. </a:t>
            </a:r>
            <a:endParaRPr lang="ja-JP" altLang="ja-JP" sz="900"/>
          </a:p>
          <a:p>
            <a:pPr marL="138113" indent="-138113"/>
            <a:r>
              <a:rPr lang="en-US" altLang="ja-JP" sz="900" dirty="0"/>
              <a:t>11. Nakanishi K, Fukuda S, Shimada K, Miyazaki C, Otsuka K, </a:t>
            </a:r>
            <a:r>
              <a:rPr lang="en-US" altLang="ja-JP" sz="900" dirty="0" err="1"/>
              <a:t>Kawarabayashi</a:t>
            </a:r>
            <a:r>
              <a:rPr lang="en-US" altLang="ja-JP" sz="900" dirty="0"/>
              <a:t> T, et al. Prognostic value of coronary flow reserve on long-term cardiovascular outcomes in patients with chronic kidney disease. </a:t>
            </a:r>
            <a:r>
              <a:rPr lang="en-US" altLang="ja-JP" sz="900" i="1" dirty="0"/>
              <a:t>Am J </a:t>
            </a:r>
            <a:r>
              <a:rPr lang="en-US" altLang="ja-JP" sz="900" i="1" dirty="0" err="1"/>
              <a:t>Cardiol</a:t>
            </a:r>
            <a:r>
              <a:rPr lang="en-US" altLang="ja-JP" sz="900" dirty="0"/>
              <a:t> 2013;112:928–932. </a:t>
            </a:r>
            <a:endParaRPr lang="ja-JP" altLang="ja-JP" sz="900"/>
          </a:p>
          <a:p>
            <a:pPr marL="138113" indent="-138113"/>
            <a:r>
              <a:rPr lang="en-US" altLang="ja-JP" sz="900" dirty="0"/>
              <a:t>12. </a:t>
            </a:r>
            <a:r>
              <a:rPr lang="en-US" altLang="ja-JP" sz="900" dirty="0" err="1"/>
              <a:t>Lintingre</a:t>
            </a:r>
            <a:r>
              <a:rPr lang="en-US" altLang="ja-JP" sz="900" dirty="0"/>
              <a:t> PF, </a:t>
            </a:r>
            <a:r>
              <a:rPr lang="en-US" altLang="ja-JP" sz="900" dirty="0" err="1"/>
              <a:t>Nivet</a:t>
            </a:r>
            <a:r>
              <a:rPr lang="en-US" altLang="ja-JP" sz="900" dirty="0"/>
              <a:t> H, Clément-</a:t>
            </a:r>
            <a:r>
              <a:rPr lang="en-US" altLang="ja-JP" sz="900" dirty="0" err="1"/>
              <a:t>Guinaudeau</a:t>
            </a:r>
            <a:r>
              <a:rPr lang="en-US" altLang="ja-JP" sz="900" dirty="0"/>
              <a:t> S, </a:t>
            </a:r>
            <a:r>
              <a:rPr lang="en-US" altLang="ja-JP" sz="900" dirty="0" err="1"/>
              <a:t>Camaioni</a:t>
            </a:r>
            <a:r>
              <a:rPr lang="en-US" altLang="ja-JP" sz="900" dirty="0"/>
              <a:t> C, </a:t>
            </a:r>
            <a:r>
              <a:rPr lang="en-US" altLang="ja-JP" sz="900" dirty="0" err="1"/>
              <a:t>Sridi</a:t>
            </a:r>
            <a:r>
              <a:rPr lang="en-US" altLang="ja-JP" sz="900" dirty="0"/>
              <a:t> S, </a:t>
            </a:r>
            <a:r>
              <a:rPr lang="en-US" altLang="ja-JP" sz="900" dirty="0" err="1"/>
              <a:t>Corneloup</a:t>
            </a:r>
            <a:r>
              <a:rPr lang="en-US" altLang="ja-JP" sz="900" dirty="0"/>
              <a:t> O, et al. High-Resolution Late Gadolinium Enhancement Magnetic Resonance for the Diagnosis of Myocardial Infarction With </a:t>
            </a:r>
            <a:r>
              <a:rPr lang="en-US" altLang="ja-JP" sz="900" dirty="0" err="1"/>
              <a:t>Nonobstructed</a:t>
            </a:r>
            <a:r>
              <a:rPr lang="en-US" altLang="ja-JP" sz="900" dirty="0"/>
              <a:t> Coronary Arteries. </a:t>
            </a:r>
            <a:r>
              <a:rPr lang="en-US" altLang="ja-JP" sz="900" i="1" dirty="0"/>
              <a:t>JACC Cardiovasc Imaging</a:t>
            </a:r>
            <a:r>
              <a:rPr lang="en-US" altLang="ja-JP" sz="900" dirty="0"/>
              <a:t> 2020;13:1135–1148. </a:t>
            </a:r>
            <a:endParaRPr lang="ja-JP" altLang="ja-JP" sz="900"/>
          </a:p>
          <a:p>
            <a:pPr marL="138113" indent="-138113"/>
            <a:r>
              <a:rPr lang="en-US" altLang="ja-JP" sz="900" dirty="0"/>
              <a:t>13. </a:t>
            </a:r>
            <a:r>
              <a:rPr lang="en-US" altLang="ja-JP" sz="900" dirty="0" err="1"/>
              <a:t>Rigo</a:t>
            </a:r>
            <a:r>
              <a:rPr lang="en-US" altLang="ja-JP" sz="900" dirty="0"/>
              <a:t> F, </a:t>
            </a:r>
            <a:r>
              <a:rPr lang="en-US" altLang="ja-JP" sz="900" dirty="0" err="1"/>
              <a:t>Richieri</a:t>
            </a:r>
            <a:r>
              <a:rPr lang="en-US" altLang="ja-JP" sz="900" dirty="0"/>
              <a:t> M, </a:t>
            </a:r>
            <a:r>
              <a:rPr lang="en-US" altLang="ja-JP" sz="900" dirty="0" err="1"/>
              <a:t>Pasanisi</a:t>
            </a:r>
            <a:r>
              <a:rPr lang="en-US" altLang="ja-JP" sz="900" dirty="0"/>
              <a:t> E, </a:t>
            </a:r>
            <a:r>
              <a:rPr lang="en-US" altLang="ja-JP" sz="900" dirty="0" err="1"/>
              <a:t>Cutaia</a:t>
            </a:r>
            <a:r>
              <a:rPr lang="en-US" altLang="ja-JP" sz="900" dirty="0"/>
              <a:t> V, </a:t>
            </a:r>
            <a:r>
              <a:rPr lang="en-US" altLang="ja-JP" sz="900" dirty="0" err="1"/>
              <a:t>Zanella</a:t>
            </a:r>
            <a:r>
              <a:rPr lang="en-US" altLang="ja-JP" sz="900" dirty="0"/>
              <a:t> C, Valentina PD, et al. Usefulness of coronary flow reserve over regional wall motion when added to dual-imaging dipyridamole echocardiography. </a:t>
            </a:r>
            <a:r>
              <a:rPr lang="en-US" altLang="ja-JP" sz="900" i="1" dirty="0"/>
              <a:t>Am J </a:t>
            </a:r>
            <a:r>
              <a:rPr lang="en-US" altLang="ja-JP" sz="900" i="1" dirty="0" err="1"/>
              <a:t>Cardiol</a:t>
            </a:r>
            <a:r>
              <a:rPr lang="en-US" altLang="ja-JP" sz="900" dirty="0"/>
              <a:t> 2003;91:269–273.</a:t>
            </a:r>
            <a:endParaRPr lang="ja-JP" altLang="ja-JP" sz="900"/>
          </a:p>
          <a:p>
            <a:endParaRPr lang="ja-JP" altLang="en-US" sz="900"/>
          </a:p>
        </p:txBody>
      </p:sp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C7ED1935-8ED1-4306-7F56-A9675FEDFC20}"/>
              </a:ext>
            </a:extLst>
          </p:cNvPr>
          <p:cNvSpPr txBox="1">
            <a:spLocks/>
          </p:cNvSpPr>
          <p:nvPr/>
        </p:nvSpPr>
        <p:spPr>
          <a:xfrm>
            <a:off x="1238080" y="4711908"/>
            <a:ext cx="6119812" cy="287338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kern="0">
                <a:solidFill>
                  <a:schemeClr val="accent1">
                    <a:lumMod val="60000"/>
                    <a:lumOff val="40000"/>
                  </a:schemeClr>
                </a:solidFill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dirty="0"/>
              <a:t>Introduc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8" y="1224000"/>
            <a:ext cx="7322915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altLang="ja-JP" dirty="0"/>
              <a:t>Thrombotic microangiopathy (TMA) is a spectrum of life-threatening syndromes, including thrombotic thrombocytopenic purpura (TTP) and haemolytic uremic syndrome (HUS).</a:t>
            </a:r>
            <a:r>
              <a:rPr lang="en-GB" altLang="ja-JP" baseline="30000" dirty="0"/>
              <a:t>1</a:t>
            </a:r>
            <a:r>
              <a:rPr lang="en-US" altLang="ja-JP" dirty="0"/>
              <a:t> </a:t>
            </a:r>
          </a:p>
          <a:p>
            <a:pPr marL="342900" indent="-342900">
              <a:spcBef>
                <a:spcPts val="1200"/>
              </a:spcBef>
              <a:buFont typeface="Arial" panose="020B0604020202020204" pitchFamily="34" charset="0"/>
              <a:buChar char="•"/>
            </a:pPr>
            <a:r>
              <a:rPr lang="en-GB" altLang="ja-JP" dirty="0"/>
              <a:t>The mechanisms underlying TMA involve platelet aggregation and increased mechanical stress in the microcirculation that contribute to multiple organ failure, including renal and heart failure, myocardial infarction/injury, and sudden cardiac death.</a:t>
            </a:r>
            <a:r>
              <a:rPr lang="en-GB" altLang="ja-JP" baseline="30000" dirty="0"/>
              <a:t>1,2</a:t>
            </a:r>
            <a:endParaRPr lang="en-GB" dirty="0"/>
          </a:p>
        </p:txBody>
      </p:sp>
      <p:sp>
        <p:nvSpPr>
          <p:cNvPr id="6" name="Text Placeholder 2">
            <a:extLst>
              <a:ext uri="{FF2B5EF4-FFF2-40B4-BE49-F238E27FC236}">
                <a16:creationId xmlns:a16="http://schemas.microsoft.com/office/drawing/2014/main" id="{7F7B5BC8-E281-E772-E0C1-4392C8DD9D0C}"/>
              </a:ext>
            </a:extLst>
          </p:cNvPr>
          <p:cNvSpPr txBox="1">
            <a:spLocks/>
          </p:cNvSpPr>
          <p:nvPr/>
        </p:nvSpPr>
        <p:spPr>
          <a:xfrm>
            <a:off x="1238080" y="4711908"/>
            <a:ext cx="6119812" cy="287338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kern="0">
                <a:solidFill>
                  <a:schemeClr val="accent1">
                    <a:lumMod val="60000"/>
                    <a:lumOff val="40000"/>
                  </a:schemeClr>
                </a:solidFill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dirty="0"/>
              <a:t>Introduc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8" y="1224000"/>
            <a:ext cx="7322915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altLang="ja-JP" dirty="0"/>
              <a:t>Although t</a:t>
            </a:r>
            <a:r>
              <a:rPr lang="en-US" altLang="ja-JP" dirty="0"/>
              <a:t>he </a:t>
            </a:r>
            <a:r>
              <a:rPr lang="en-GB" altLang="ja-JP" dirty="0"/>
              <a:t>assessment of the coronary microvascular function is important to understand the pathophysiology of TMA, there is limited knowledge on in vivo evaluations of coronary microvascular dysfunction (CMD) and its recovery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altLang="ja-JP" dirty="0"/>
              <a:t>Herein, we describe a case of cardiac troponin elevation with CMD associated with TMA, demonstrating non-invasive assessment of the recovery of the coronary microvascular function. </a:t>
            </a:r>
            <a:endParaRPr lang="en-GB" dirty="0"/>
          </a:p>
        </p:txBody>
      </p:sp>
      <p:sp>
        <p:nvSpPr>
          <p:cNvPr id="6" name="Text Placeholder 2">
            <a:extLst>
              <a:ext uri="{FF2B5EF4-FFF2-40B4-BE49-F238E27FC236}">
                <a16:creationId xmlns:a16="http://schemas.microsoft.com/office/drawing/2014/main" id="{AAC83DCC-1601-B006-649A-3C492307C0AF}"/>
              </a:ext>
            </a:extLst>
          </p:cNvPr>
          <p:cNvSpPr txBox="1">
            <a:spLocks/>
          </p:cNvSpPr>
          <p:nvPr/>
        </p:nvSpPr>
        <p:spPr>
          <a:xfrm>
            <a:off x="1238080" y="4711908"/>
            <a:ext cx="6119812" cy="287338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kern="0">
                <a:solidFill>
                  <a:schemeClr val="accent1">
                    <a:lumMod val="60000"/>
                    <a:lumOff val="40000"/>
                  </a:schemeClr>
                </a:solidFill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6979049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br>
              <a:rPr lang="en-GB" sz="3200" dirty="0"/>
            </a:br>
            <a:r>
              <a:rPr lang="en-GB" sz="2200" dirty="0"/>
              <a:t>History and Examination Finding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59728" y="1695261"/>
            <a:ext cx="7128392" cy="2566496"/>
          </a:xfrm>
        </p:spPr>
        <p:txBody>
          <a:bodyPr/>
          <a:lstStyle/>
          <a:p>
            <a:pPr marL="342900" indent="-342900">
              <a:buFont typeface="Wingdings" pitchFamily="2" charset="2"/>
              <a:buChar char="ü"/>
            </a:pPr>
            <a:r>
              <a:rPr lang="en-US" altLang="ja-JP" dirty="0"/>
              <a:t>An 80-year-old Asian woman.</a:t>
            </a:r>
          </a:p>
          <a:p>
            <a:pPr marL="342900" indent="-342900">
              <a:buFont typeface="Wingdings" pitchFamily="2" charset="2"/>
              <a:buChar char="ü"/>
            </a:pPr>
            <a:r>
              <a:rPr lang="en-US" altLang="ja-JP" dirty="0"/>
              <a:t>History of type 2 diabetes mellitus.</a:t>
            </a:r>
          </a:p>
          <a:p>
            <a:pPr marL="342900" indent="-342900">
              <a:buFont typeface="Wingdings" pitchFamily="2" charset="2"/>
              <a:buChar char="ü"/>
            </a:pPr>
            <a:r>
              <a:rPr lang="en-US" altLang="ja-JP" dirty="0"/>
              <a:t>Worsening back pain, dyspnea on exertion, jaundice, and fever. </a:t>
            </a:r>
          </a:p>
          <a:p>
            <a:pPr marL="342900" indent="-342900">
              <a:buFont typeface="Wingdings" pitchFamily="2" charset="2"/>
              <a:buChar char="ü"/>
            </a:pPr>
            <a:r>
              <a:rPr lang="en-US" altLang="ja-JP" dirty="0"/>
              <a:t>Typical TTP symptoms (fever, thrombocytopenia, microangiopathic hemolytic anemia, transient neurologic deficits, and renal failure).</a:t>
            </a:r>
          </a:p>
          <a:p>
            <a:pPr marL="342900" indent="-342900">
              <a:buFont typeface="Wingdings" pitchFamily="2" charset="2"/>
              <a:buChar char="ü"/>
            </a:pPr>
            <a:r>
              <a:rPr lang="en-US" altLang="ja-JP" dirty="0"/>
              <a:t>Cardiac</a:t>
            </a:r>
            <a:r>
              <a:rPr lang="ja-JP" altLang="en-US"/>
              <a:t> </a:t>
            </a:r>
            <a:r>
              <a:rPr lang="en-US" altLang="ja-JP" dirty="0"/>
              <a:t>biomarker</a:t>
            </a:r>
            <a:r>
              <a:rPr lang="ja-JP" altLang="en-US"/>
              <a:t> </a:t>
            </a:r>
            <a:r>
              <a:rPr lang="en-US" altLang="ja-JP" dirty="0"/>
              <a:t>elevation.</a:t>
            </a:r>
            <a:endParaRPr lang="en-GB" dirty="0"/>
          </a:p>
        </p:txBody>
      </p:sp>
      <p:pic>
        <p:nvPicPr>
          <p:cNvPr id="7" name="Picture 5" descr="A picture containing person, person, indoor, preparing&#10;&#10;Description automatically generated">
            <a:extLst>
              <a:ext uri="{FF2B5EF4-FFF2-40B4-BE49-F238E27FC236}">
                <a16:creationId xmlns:a16="http://schemas.microsoft.com/office/drawing/2014/main" id="{BEACB10E-2208-A548-952A-BE95080EC5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913" t="31406" r="29475" b="22028"/>
          <a:stretch/>
        </p:blipFill>
        <p:spPr>
          <a:xfrm rot="5400000">
            <a:off x="4940693" y="851405"/>
            <a:ext cx="1806353" cy="1377180"/>
          </a:xfrm>
          <a:prstGeom prst="rect">
            <a:avLst/>
          </a:prstGeom>
        </p:spPr>
      </p:pic>
      <p:pic>
        <p:nvPicPr>
          <p:cNvPr id="8" name="Picture 7" descr="A close-up of a hand&#10;&#10;Description automatically generated with low confidence">
            <a:extLst>
              <a:ext uri="{FF2B5EF4-FFF2-40B4-BE49-F238E27FC236}">
                <a16:creationId xmlns:a16="http://schemas.microsoft.com/office/drawing/2014/main" id="{F3A544D1-62E2-8847-8DC2-04E4E574370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753" t="19162" r="35487" b="16606"/>
          <a:stretch/>
        </p:blipFill>
        <p:spPr>
          <a:xfrm rot="5400000">
            <a:off x="6368467" y="807142"/>
            <a:ext cx="1806349" cy="1445053"/>
          </a:xfrm>
          <a:prstGeom prst="rect">
            <a:avLst/>
          </a:prstGeom>
        </p:spPr>
      </p:pic>
      <p:sp>
        <p:nvSpPr>
          <p:cNvPr id="9" name="Text Placeholder 2">
            <a:extLst>
              <a:ext uri="{FF2B5EF4-FFF2-40B4-BE49-F238E27FC236}">
                <a16:creationId xmlns:a16="http://schemas.microsoft.com/office/drawing/2014/main" id="{F4733BE7-6956-099C-D487-48EA9B5B43A1}"/>
              </a:ext>
            </a:extLst>
          </p:cNvPr>
          <p:cNvSpPr txBox="1">
            <a:spLocks/>
          </p:cNvSpPr>
          <p:nvPr/>
        </p:nvSpPr>
        <p:spPr>
          <a:xfrm>
            <a:off x="1238080" y="4711908"/>
            <a:ext cx="6119812" cy="287338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kern="0">
                <a:solidFill>
                  <a:schemeClr val="accent1">
                    <a:lumMod val="60000"/>
                    <a:lumOff val="40000"/>
                  </a:schemeClr>
                </a:solidFill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br>
              <a:rPr lang="en-GB" sz="3600" dirty="0"/>
            </a:br>
            <a:r>
              <a:rPr lang="en-GB" sz="220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3732085" cy="3168000"/>
          </a:xfrm>
        </p:spPr>
        <p:txBody>
          <a:bodyPr>
            <a:normAutofit lnSpcReduction="10000"/>
          </a:bodyPr>
          <a:lstStyle/>
          <a:p>
            <a:pPr marL="342900" indent="-342900">
              <a:buFont typeface="Wingdings" pitchFamily="2" charset="2"/>
              <a:buChar char="ü"/>
            </a:pPr>
            <a:r>
              <a:rPr lang="en-GB" altLang="ja-JP" dirty="0"/>
              <a:t>12-lead electrocardiogram on admission showed ST segment depression in V5 and V6 leads. </a:t>
            </a:r>
          </a:p>
          <a:p>
            <a:pPr marL="342900" indent="-342900">
              <a:buFont typeface="Wingdings" pitchFamily="2" charset="2"/>
              <a:buChar char="ü"/>
            </a:pPr>
            <a:r>
              <a:rPr lang="en-GB" altLang="ja-JP" dirty="0"/>
              <a:t>Transthoracic Doppler echocardiography (TTDE) revealed a preserved left ventricular ejection fraction (50%) with hypokinesis of the inferior-posterior wall, suggesting non-ST-segment myocardial infarction. </a:t>
            </a:r>
            <a:endParaRPr lang="en-GB" dirty="0"/>
          </a:p>
        </p:txBody>
      </p:sp>
      <p:pic>
        <p:nvPicPr>
          <p:cNvPr id="7" name="図 4" descr="建物, 障子 が含まれている画像&#10;&#10;自動的に生成された説明">
            <a:extLst>
              <a:ext uri="{FF2B5EF4-FFF2-40B4-BE49-F238E27FC236}">
                <a16:creationId xmlns:a16="http://schemas.microsoft.com/office/drawing/2014/main" id="{510D7216-571D-BB46-BEBB-5497998151D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10" r="68025" b="7061"/>
          <a:stretch/>
        </p:blipFill>
        <p:spPr>
          <a:xfrm>
            <a:off x="4822152" y="1224001"/>
            <a:ext cx="2057286" cy="3026871"/>
          </a:xfrm>
          <a:prstGeom prst="rect">
            <a:avLst/>
          </a:prstGeom>
        </p:spPr>
      </p:pic>
      <p:pic>
        <p:nvPicPr>
          <p:cNvPr id="8" name="図 5" descr="ダイアグラム, タイムライン&#10;&#10;自動的に生成された説明">
            <a:extLst>
              <a:ext uri="{FF2B5EF4-FFF2-40B4-BE49-F238E27FC236}">
                <a16:creationId xmlns:a16="http://schemas.microsoft.com/office/drawing/2014/main" id="{56A1F43D-A197-3C41-890E-5C47EDB546D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8532" b="2153"/>
          <a:stretch/>
        </p:blipFill>
        <p:spPr>
          <a:xfrm>
            <a:off x="6313561" y="1224000"/>
            <a:ext cx="1858440" cy="3026872"/>
          </a:xfrm>
          <a:prstGeom prst="rect">
            <a:avLst/>
          </a:prstGeom>
        </p:spPr>
      </p:pic>
      <p:sp>
        <p:nvSpPr>
          <p:cNvPr id="9" name="Text Placeholder 2">
            <a:extLst>
              <a:ext uri="{FF2B5EF4-FFF2-40B4-BE49-F238E27FC236}">
                <a16:creationId xmlns:a16="http://schemas.microsoft.com/office/drawing/2014/main" id="{AB3E3593-B2DA-FF6F-F38D-82ADCBB1E6B3}"/>
              </a:ext>
            </a:extLst>
          </p:cNvPr>
          <p:cNvSpPr txBox="1">
            <a:spLocks/>
          </p:cNvSpPr>
          <p:nvPr/>
        </p:nvSpPr>
        <p:spPr>
          <a:xfrm>
            <a:off x="1238080" y="4711908"/>
            <a:ext cx="6119812" cy="287338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kern="0">
                <a:solidFill>
                  <a:schemeClr val="accent1">
                    <a:lumMod val="60000"/>
                    <a:lumOff val="40000"/>
                  </a:schemeClr>
                </a:solidFill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br>
              <a:rPr lang="en-GB" sz="3600" dirty="0"/>
            </a:br>
            <a:r>
              <a:rPr lang="en-GB" sz="220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825820" y="1224000"/>
            <a:ext cx="3665314" cy="3579998"/>
          </a:xfrm>
        </p:spPr>
        <p:txBody>
          <a:bodyPr>
            <a:normAutofit/>
          </a:bodyPr>
          <a:lstStyle/>
          <a:p>
            <a:pPr marL="342900" indent="-342900">
              <a:buFont typeface="Wingdings" pitchFamily="2" charset="2"/>
              <a:buChar char="ü"/>
            </a:pPr>
            <a:r>
              <a:rPr lang="en-US" altLang="ja-JP" dirty="0"/>
              <a:t>Additional magnetic resonance imaging (MRI) revealed iliopsoas abscess due to methicillin-resistant coagulase negative staphylococci, supporting our diagnosis of TTP caused by infection. </a:t>
            </a:r>
          </a:p>
          <a:p>
            <a:pPr marL="342900" indent="-342900">
              <a:buFont typeface="Wingdings" pitchFamily="2" charset="2"/>
              <a:buChar char="ü"/>
            </a:pPr>
            <a:r>
              <a:rPr lang="en-GB" altLang="ja-JP" dirty="0"/>
              <a:t>ADAMTS13 activity (day 4) was preserved (34%, two weeks after the test), and the diagnosis was TMA. </a:t>
            </a:r>
            <a:endParaRPr lang="en-GB" dirty="0"/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B51E18CA-5660-D940-BE34-F8EAEFBD991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47" t="8341" r="9138" b="10271"/>
          <a:stretch/>
        </p:blipFill>
        <p:spPr>
          <a:xfrm>
            <a:off x="4652866" y="1224000"/>
            <a:ext cx="1902627" cy="2093625"/>
          </a:xfrm>
          <a:prstGeom prst="rect">
            <a:avLst/>
          </a:prstGeom>
        </p:spPr>
      </p:pic>
      <p:pic>
        <p:nvPicPr>
          <p:cNvPr id="9" name="図 8" descr="探す, 立つ, 写真, 暗い が含まれている画像&#10;&#10;自動的に生成された説明">
            <a:extLst>
              <a:ext uri="{FF2B5EF4-FFF2-40B4-BE49-F238E27FC236}">
                <a16:creationId xmlns:a16="http://schemas.microsoft.com/office/drawing/2014/main" id="{5AB04E7A-7BDF-6941-B96B-5C8D6483986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22" t="32990" r="30939"/>
          <a:stretch/>
        </p:blipFill>
        <p:spPr>
          <a:xfrm>
            <a:off x="6555493" y="1224000"/>
            <a:ext cx="1616507" cy="2093625"/>
          </a:xfrm>
          <a:prstGeom prst="rect">
            <a:avLst/>
          </a:prstGeom>
        </p:spPr>
      </p:pic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DD439178-0687-581B-E39B-12472956F6AF}"/>
              </a:ext>
            </a:extLst>
          </p:cNvPr>
          <p:cNvSpPr txBox="1">
            <a:spLocks/>
          </p:cNvSpPr>
          <p:nvPr/>
        </p:nvSpPr>
        <p:spPr>
          <a:xfrm>
            <a:off x="1238080" y="4711908"/>
            <a:ext cx="6119812" cy="287338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kern="0">
                <a:solidFill>
                  <a:schemeClr val="accent1">
                    <a:lumMod val="60000"/>
                    <a:lumOff val="40000"/>
                  </a:schemeClr>
                </a:solidFill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0674453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br>
              <a:rPr lang="en-GB" sz="3600" dirty="0"/>
            </a:br>
            <a:r>
              <a:rPr lang="en-GB" sz="220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67841" y="1159135"/>
            <a:ext cx="4091938" cy="3777990"/>
          </a:xfrm>
        </p:spPr>
        <p:txBody>
          <a:bodyPr>
            <a:normAutofit lnSpcReduction="10000"/>
          </a:bodyPr>
          <a:lstStyle/>
          <a:p>
            <a:pPr marL="342900" indent="-342900">
              <a:buFont typeface="Wingdings" pitchFamily="2" charset="2"/>
              <a:buChar char="ü"/>
            </a:pPr>
            <a:r>
              <a:rPr lang="en-GB" altLang="ja-JP" dirty="0"/>
              <a:t>Cardiac MRI showed no evidence of an acute infarct area in the left ventricular myocardium (LV asynergy was improved).</a:t>
            </a:r>
            <a:r>
              <a:rPr lang="ja-JP" altLang="ja-JP"/>
              <a:t> </a:t>
            </a:r>
            <a:endParaRPr lang="en-US" altLang="ja-JP" dirty="0"/>
          </a:p>
          <a:p>
            <a:pPr marL="342900" indent="-342900">
              <a:buFont typeface="Wingdings" pitchFamily="2" charset="2"/>
              <a:buChar char="ü"/>
            </a:pPr>
            <a:r>
              <a:rPr lang="en-GB" altLang="ja-JP" dirty="0"/>
              <a:t>Coronary angiography revealed no significant luminal stenosis in the LAD and left circumflex artery.</a:t>
            </a:r>
            <a:r>
              <a:rPr lang="ja-JP" altLang="ja-JP" dirty="0"/>
              <a:t> </a:t>
            </a:r>
            <a:endParaRPr lang="en-US" altLang="ja-JP" dirty="0"/>
          </a:p>
          <a:p>
            <a:pPr marL="342900" indent="-342900">
              <a:buFont typeface="Wingdings" pitchFamily="2" charset="2"/>
              <a:buChar char="ü"/>
            </a:pPr>
            <a:r>
              <a:rPr lang="en-US" altLang="ja-JP" dirty="0"/>
              <a:t>Non-invasive assessment of coronary microvascular function and its recovery can provide mechanistic insights into the cardiac involvement in TMA.</a:t>
            </a:r>
            <a:endParaRPr lang="ja-JP" altLang="ja-JP" dirty="0"/>
          </a:p>
        </p:txBody>
      </p:sp>
      <p:pic>
        <p:nvPicPr>
          <p:cNvPr id="10" name="Picture 24" descr="A picture containing text&#10;&#10;Description automatically generated">
            <a:extLst>
              <a:ext uri="{FF2B5EF4-FFF2-40B4-BE49-F238E27FC236}">
                <a16:creationId xmlns:a16="http://schemas.microsoft.com/office/drawing/2014/main" id="{CAC09AF5-CAA8-8342-837A-A91C15421D7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803" t="15111" b="29857"/>
          <a:stretch/>
        </p:blipFill>
        <p:spPr>
          <a:xfrm>
            <a:off x="4910356" y="859930"/>
            <a:ext cx="2058737" cy="1581012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696DDF6-493E-6549-A01A-46B67A4FE51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6097" y="851334"/>
            <a:ext cx="1810063" cy="1810063"/>
          </a:xfrm>
          <a:prstGeom prst="rect">
            <a:avLst/>
          </a:prstGeom>
        </p:spPr>
      </p:pic>
      <p:pic>
        <p:nvPicPr>
          <p:cNvPr id="7" name="Picture 6" descr="Graphical user interface, website&#10;&#10;Description automatically generated">
            <a:extLst>
              <a:ext uri="{FF2B5EF4-FFF2-40B4-BE49-F238E27FC236}">
                <a16:creationId xmlns:a16="http://schemas.microsoft.com/office/drawing/2014/main" id="{31616EF6-1CB4-4F48-1395-0F19AB8D592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5" t="10985"/>
          <a:stretch/>
        </p:blipFill>
        <p:spPr>
          <a:xfrm>
            <a:off x="4910358" y="2449108"/>
            <a:ext cx="3565802" cy="1872408"/>
          </a:xfrm>
          <a:prstGeom prst="rect">
            <a:avLst/>
          </a:prstGeom>
        </p:spPr>
      </p:pic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46653BE1-70A3-7440-3777-AF54A683B212}"/>
              </a:ext>
            </a:extLst>
          </p:cNvPr>
          <p:cNvSpPr txBox="1">
            <a:spLocks/>
          </p:cNvSpPr>
          <p:nvPr/>
        </p:nvSpPr>
        <p:spPr>
          <a:xfrm>
            <a:off x="1238080" y="4711908"/>
            <a:ext cx="6119812" cy="287338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kern="0">
                <a:solidFill>
                  <a:schemeClr val="accent1">
                    <a:lumMod val="60000"/>
                    <a:lumOff val="40000"/>
                  </a:schemeClr>
                </a:solidFill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34786594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br>
              <a:rPr lang="en-GB" sz="3200" dirty="0"/>
            </a:br>
            <a:r>
              <a:rPr lang="en-GB" sz="2200" dirty="0"/>
              <a:t>Manageme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347407" cy="3511286"/>
          </a:xfrm>
        </p:spPr>
        <p:txBody>
          <a:bodyPr>
            <a:normAutofit lnSpcReduction="10000"/>
          </a:bodyPr>
          <a:lstStyle/>
          <a:p>
            <a:pPr marL="342900" indent="-342900">
              <a:buFont typeface="Wingdings" pitchFamily="2" charset="2"/>
              <a:buChar char="ü"/>
            </a:pPr>
            <a:r>
              <a:rPr lang="en-GB" altLang="ja-JP" dirty="0"/>
              <a:t>Non-ST-elevation myocardial infarction and heart failure was managed with non-invasive respiratory support of the bi-level positive airway pressure, carperitide, and diuretics, in the intensive-care unit. </a:t>
            </a:r>
          </a:p>
          <a:p>
            <a:pPr marL="342900" indent="-342900">
              <a:buFont typeface="Wingdings" pitchFamily="2" charset="2"/>
              <a:buChar char="ü"/>
            </a:pPr>
            <a:r>
              <a:rPr lang="en-GB" altLang="ja-JP" dirty="0"/>
              <a:t>Fresh frozen plasma (FFP) infusion.</a:t>
            </a:r>
          </a:p>
          <a:p>
            <a:pPr marL="342900" indent="-342900">
              <a:buFont typeface="Wingdings" pitchFamily="2" charset="2"/>
              <a:buChar char="ü"/>
            </a:pPr>
            <a:r>
              <a:rPr lang="en-GB" altLang="ja-JP" dirty="0"/>
              <a:t>Plasma exchange (preferably starting within 4-8 hours).</a:t>
            </a:r>
          </a:p>
          <a:p>
            <a:pPr marL="342900" indent="-342900">
              <a:buFont typeface="Wingdings" pitchFamily="2" charset="2"/>
              <a:buChar char="ü"/>
            </a:pPr>
            <a:r>
              <a:rPr lang="en-GB" altLang="ja-JP" dirty="0"/>
              <a:t>Steroid pulse therapy (1 g/day for 3 days) was administered, followed by high-dose oral steroid therapy (prednisolone 40 mg/day). </a:t>
            </a:r>
          </a:p>
          <a:p>
            <a:pPr marL="342900" indent="-342900">
              <a:buFont typeface="Wingdings" pitchFamily="2" charset="2"/>
              <a:buChar char="ü"/>
            </a:pPr>
            <a:r>
              <a:rPr lang="en-GB" altLang="ja-JP" dirty="0"/>
              <a:t>Oral aspirin (100 mg/day) after the recovery of platelet count (&gt;50,000</a:t>
            </a:r>
            <a:r>
              <a:rPr lang="en-US" altLang="ja-JP" sz="18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/µL</a:t>
            </a:r>
            <a:r>
              <a:rPr lang="en-GB" altLang="ja-JP" dirty="0"/>
              <a:t>).</a:t>
            </a:r>
          </a:p>
          <a:p>
            <a:pPr marL="342900" indent="-342900">
              <a:buFont typeface="Wingdings" pitchFamily="2" charset="2"/>
              <a:buChar char="Ø"/>
            </a:pPr>
            <a:endParaRPr lang="ja-JP" altLang="ja-JP" dirty="0"/>
          </a:p>
          <a:p>
            <a:endParaRPr lang="en-GB" dirty="0"/>
          </a:p>
        </p:txBody>
      </p:sp>
      <p:sp>
        <p:nvSpPr>
          <p:cNvPr id="6" name="Text Placeholder 2">
            <a:extLst>
              <a:ext uri="{FF2B5EF4-FFF2-40B4-BE49-F238E27FC236}">
                <a16:creationId xmlns:a16="http://schemas.microsoft.com/office/drawing/2014/main" id="{10E437A0-3706-6269-A324-18548719BEBA}"/>
              </a:ext>
            </a:extLst>
          </p:cNvPr>
          <p:cNvSpPr txBox="1">
            <a:spLocks/>
          </p:cNvSpPr>
          <p:nvPr/>
        </p:nvSpPr>
        <p:spPr>
          <a:xfrm>
            <a:off x="1238080" y="4711908"/>
            <a:ext cx="6119812" cy="287338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kern="0">
                <a:solidFill>
                  <a:schemeClr val="accent1">
                    <a:lumMod val="60000"/>
                    <a:lumOff val="40000"/>
                  </a:schemeClr>
                </a:solidFill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550" y="1223999"/>
            <a:ext cx="7339693" cy="3854635"/>
          </a:xfrm>
        </p:spPr>
        <p:txBody>
          <a:bodyPr>
            <a:normAutofit/>
          </a:bodyPr>
          <a:lstStyle/>
          <a:p>
            <a:pPr marL="342900" indent="-342900">
              <a:spcBef>
                <a:spcPts val="1200"/>
              </a:spcBef>
              <a:buFont typeface="Wingdings" pitchFamily="2" charset="2"/>
              <a:buChar char="l"/>
            </a:pPr>
            <a:r>
              <a:rPr lang="en-GB" altLang="ja-JP" dirty="0"/>
              <a:t>CMD is the mechanism underlying myocardial infarction/injury with or without epicardial obstructive coronary artery stenosis.</a:t>
            </a:r>
            <a:r>
              <a:rPr lang="en-GB" altLang="ja-JP" baseline="30000" dirty="0"/>
              <a:t>4</a:t>
            </a:r>
            <a:r>
              <a:rPr lang="en-GB" altLang="ja-JP" dirty="0"/>
              <a:t> TMA is a spectrum of life-threatening syndromes in which haemolytic anaemia and thrombocytopaenia are associated with multiple organ damage.</a:t>
            </a:r>
            <a:r>
              <a:rPr lang="en-GB" altLang="ja-JP" baseline="30000" dirty="0"/>
              <a:t>1,2</a:t>
            </a:r>
            <a:r>
              <a:rPr lang="en-GB" altLang="ja-JP" dirty="0"/>
              <a:t> </a:t>
            </a:r>
            <a:endParaRPr lang="en-GB" sz="2400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971550" y="3028950"/>
            <a:ext cx="7200900" cy="1363050"/>
          </a:xfrm>
        </p:spPr>
        <p:txBody>
          <a:bodyPr>
            <a:normAutofit/>
          </a:bodyPr>
          <a:lstStyle/>
          <a:p>
            <a:pPr marL="342900" indent="-342900">
              <a:buFont typeface="Wingdings" pitchFamily="2" charset="2"/>
              <a:buChar char="l"/>
            </a:pPr>
            <a:r>
              <a:rPr lang="en-GB" altLang="ja-JP" dirty="0"/>
              <a:t>Complications include acute myocardial infarction/injury as the major cause of death in patients with TMA. Cardiovascular system complications can be explained by microvascular occlusions due to platelet aggregation. </a:t>
            </a:r>
            <a:endParaRPr lang="en-GB" dirty="0"/>
          </a:p>
        </p:txBody>
      </p:sp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60864816-A30F-084A-15C8-F514DCCF8598}"/>
              </a:ext>
            </a:extLst>
          </p:cNvPr>
          <p:cNvSpPr txBox="1">
            <a:spLocks/>
          </p:cNvSpPr>
          <p:nvPr/>
        </p:nvSpPr>
        <p:spPr>
          <a:xfrm>
            <a:off x="1238080" y="4711908"/>
            <a:ext cx="6119812" cy="287338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kern="0">
                <a:solidFill>
                  <a:schemeClr val="accent1">
                    <a:lumMod val="60000"/>
                    <a:lumOff val="40000"/>
                  </a:schemeClr>
                </a:solidFill>
                <a:ea typeface="ＭＳ Ｐゴシック" panose="020B0600070205080204" pitchFamily="34" charset="-128"/>
              </a:rPr>
              <a:t>EHJ-CR-D-22-00012</a:t>
            </a:r>
            <a:endParaRPr lang="en-GB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0</TotalTime>
  <Words>1135</Words>
  <Application>Microsoft Macintosh PowerPoint</Application>
  <PresentationFormat>画面に合わせる (16:9)</PresentationFormat>
  <Paragraphs>72</Paragraphs>
  <Slides>1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11</vt:i4>
      </vt:variant>
    </vt:vector>
  </HeadingPairs>
  <TitlesOfParts>
    <vt:vector size="20" baseType="lpstr">
      <vt:lpstr>Arial</vt:lpstr>
      <vt:lpstr>Calibri</vt:lpstr>
      <vt:lpstr>Times New Roman</vt:lpstr>
      <vt:lpstr>Wingdings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Evaluations of Coronary Microvascular Dysfunction in a Patient with Thrombotic Microangiopathy and Cardiac Troponin Elevation: A Case Report </vt:lpstr>
      <vt:lpstr>Introduction</vt:lpstr>
      <vt:lpstr>Introduction</vt:lpstr>
      <vt:lpstr>Case Presentation History and Examination Findings</vt:lpstr>
      <vt:lpstr>Case Presentation Investigations</vt:lpstr>
      <vt:lpstr>Case Presentation Investigations</vt:lpstr>
      <vt:lpstr>Case Presentation Investigations</vt:lpstr>
      <vt:lpstr>Case Presentation Management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kenichiro otsuka</cp:lastModifiedBy>
  <cp:revision>43</cp:revision>
  <dcterms:created xsi:type="dcterms:W3CDTF">2017-10-02T09:19:02Z</dcterms:created>
  <dcterms:modified xsi:type="dcterms:W3CDTF">2022-07-11T12:31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